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674" r:id="rId2"/>
    <p:sldId id="697" r:id="rId3"/>
    <p:sldId id="691" r:id="rId4"/>
    <p:sldId id="696" r:id="rId5"/>
    <p:sldId id="695" r:id="rId6"/>
    <p:sldId id="698" r:id="rId7"/>
  </p:sldIdLst>
  <p:sldSz cx="13717588" cy="18291175"/>
  <p:notesSz cx="6797675" cy="9926638"/>
  <p:defaultTextStyle>
    <a:defPPr>
      <a:defRPr lang="ko-KR"/>
    </a:defPPr>
    <a:lvl1pPr algn="l" defTabSz="1828800" rtl="0" eaLnBrk="0" fontAlgn="base" hangingPunct="0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914400" indent="-457200" algn="l" defTabSz="1828800" rtl="0" eaLnBrk="0" fontAlgn="base" hangingPunct="0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1828800" indent="-914400" algn="l" defTabSz="1828800" rtl="0" eaLnBrk="0" fontAlgn="base" hangingPunct="0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2743200" indent="-1371600" algn="l" defTabSz="1828800" rtl="0" eaLnBrk="0" fontAlgn="base" hangingPunct="0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3657600" indent="-1828800" algn="l" defTabSz="1828800" rtl="0" eaLnBrk="0" fontAlgn="base" hangingPunct="0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sz="3600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800">
          <p15:clr>
            <a:srgbClr val="A4A3A4"/>
          </p15:clr>
        </p15:guide>
        <p15:guide id="2" pos="1644">
          <p15:clr>
            <a:srgbClr val="A4A3A4"/>
          </p15:clr>
        </p15:guide>
        <p15:guide id="3" pos="1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F0000"/>
    <a:srgbClr val="0000FF"/>
    <a:srgbClr val="008000"/>
    <a:srgbClr val="009900"/>
    <a:srgbClr val="40DC4F"/>
    <a:srgbClr val="CC6600"/>
    <a:srgbClr val="FF00FF"/>
    <a:srgbClr val="F9E3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27" autoAdjust="0"/>
    <p:restoredTop sz="93979" autoAdjust="0"/>
  </p:normalViewPr>
  <p:slideViewPr>
    <p:cSldViewPr>
      <p:cViewPr>
        <p:scale>
          <a:sx n="75" d="100"/>
          <a:sy n="75" d="100"/>
        </p:scale>
        <p:origin x="228" y="-270"/>
      </p:cViewPr>
      <p:guideLst>
        <p:guide orient="horz" pos="8800"/>
        <p:guide pos="1644"/>
        <p:guide pos="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A6D7CA21-E230-4779-95DF-DEAAA19A6D6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l" defTabSz="1828937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7623DF3-A672-4A35-B940-0980FF7BB53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r" defTabSz="1828937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D5E8A13D-E33B-4856-86FA-BC8E1C35BBF5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4" name="슬라이드 이미지 개체 틀 3">
            <a:extLst>
              <a:ext uri="{FF2B5EF4-FFF2-40B4-BE49-F238E27FC236}">
                <a16:creationId xmlns:a16="http://schemas.microsoft.com/office/drawing/2014/main" id="{14FC1CC1-91BD-4452-8114-42738781C2C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0" tIns="45705" rIns="91410" bIns="45705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>
            <a:extLst>
              <a:ext uri="{FF2B5EF4-FFF2-40B4-BE49-F238E27FC236}">
                <a16:creationId xmlns:a16="http://schemas.microsoft.com/office/drawing/2014/main" id="{DB6D625E-32AA-430E-A534-908400AB8A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10" tIns="45705" rIns="91410" bIns="45705" rtlCol="0"/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8AC6878-271B-437B-9A46-BF63D4113F33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10" tIns="45705" rIns="91410" bIns="45705" rtlCol="0" anchor="b"/>
          <a:lstStyle>
            <a:lvl1pPr algn="l" defTabSz="1828937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7AFA0F0-F9B7-4E2E-AF4C-14EE57D0C15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wrap="square" lIns="91410" tIns="45705" rIns="91410" bIns="45705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</a:lstStyle>
          <a:p>
            <a:pPr>
              <a:defRPr/>
            </a:pPr>
            <a:fld id="{1AF71629-CB31-4C48-9192-0C163190775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73368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827213" rtl="0" eaLnBrk="0" fontAlgn="base" latinLnBrk="1" hangingPunct="0">
      <a:spcBef>
        <a:spcPct val="30000"/>
      </a:spcBef>
      <a:spcAft>
        <a:spcPct val="0"/>
      </a:spcAft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2813" algn="l" defTabSz="1827213" rtl="0" eaLnBrk="0" fontAlgn="base" latinLnBrk="1" hangingPunct="0">
      <a:spcBef>
        <a:spcPct val="30000"/>
      </a:spcBef>
      <a:spcAft>
        <a:spcPct val="0"/>
      </a:spcAft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7213" algn="l" defTabSz="1827213" rtl="0" eaLnBrk="0" fontAlgn="base" latinLnBrk="1" hangingPunct="0">
      <a:spcBef>
        <a:spcPct val="30000"/>
      </a:spcBef>
      <a:spcAft>
        <a:spcPct val="0"/>
      </a:spcAft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1613" algn="l" defTabSz="1827213" rtl="0" eaLnBrk="0" fontAlgn="base" latinLnBrk="1" hangingPunct="0">
      <a:spcBef>
        <a:spcPct val="30000"/>
      </a:spcBef>
      <a:spcAft>
        <a:spcPct val="0"/>
      </a:spcAft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6013" algn="l" defTabSz="1827213" rtl="0" eaLnBrk="0" fontAlgn="base" latinLnBrk="1" hangingPunct="0">
      <a:spcBef>
        <a:spcPct val="30000"/>
      </a:spcBef>
      <a:spcAft>
        <a:spcPct val="0"/>
      </a:spcAft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771" algn="l" defTabSz="1828709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126" algn="l" defTabSz="1828709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480" algn="l" defTabSz="1828709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4834" algn="l" defTabSz="1828709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028819" y="5682123"/>
            <a:ext cx="11659950" cy="392074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057638" y="10364999"/>
            <a:ext cx="9602312" cy="467441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44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28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43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57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723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868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4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157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1F5824-C350-453D-9236-83EF26F1310B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5D60C2-CEBA-4D8D-A104-211E9F88AE3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485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4F567C-302E-454E-8B6E-DC0810A1A800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9D420D-40B1-4114-82A1-C3FB34C66AD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4590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5663297" y="1151669"/>
            <a:ext cx="4860693" cy="24583001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081214" y="1151669"/>
            <a:ext cx="14353456" cy="24583001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A81F48-9366-444F-A49B-1E4DE675D926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2819B-CF79-47E5-B6C1-3AD5B582D9B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865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16265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6"/>
          <p:cNvGrpSpPr>
            <a:grpSpLocks/>
          </p:cNvGrpSpPr>
          <p:nvPr userDrawn="1"/>
        </p:nvGrpSpPr>
        <p:grpSpPr bwMode="auto">
          <a:xfrm>
            <a:off x="404813" y="4930775"/>
            <a:ext cx="13181012" cy="2549525"/>
            <a:chOff x="405184" y="4930982"/>
            <a:chExt cx="13180496" cy="2549895"/>
          </a:xfrm>
        </p:grpSpPr>
        <p:sp>
          <p:nvSpPr>
            <p:cNvPr id="3" name="직사각형 2">
              <a:extLst>
                <a:ext uri="{FF2B5EF4-FFF2-40B4-BE49-F238E27FC236}">
                  <a16:creationId xmlns:a16="http://schemas.microsoft.com/office/drawing/2014/main" id="{EB9D3621-4267-48A7-9485-FBDDCED73D8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05184" y="4930982"/>
              <a:ext cx="3076455" cy="254989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2871" tIns="91435" rIns="182871" bIns="91435" anchor="ctr"/>
            <a:lstStyle/>
            <a:p>
              <a:pPr algn="ctr" defTabSz="1828937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8844D687-09CB-440E-B31D-E623DA4E941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73727" y="4930982"/>
              <a:ext cx="3076455" cy="254989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2871" tIns="91435" rIns="182871" bIns="91435" anchor="ctr"/>
            <a:lstStyle/>
            <a:p>
              <a:pPr algn="ctr" defTabSz="1828937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 sz="1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2E075AD8-E87C-4933-B6A9-B607EDCE3B0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140682" y="4930982"/>
              <a:ext cx="3076455" cy="254989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2871" tIns="91435" rIns="182871" bIns="91435" anchor="ctr"/>
            <a:lstStyle/>
            <a:p>
              <a:pPr algn="ctr" defTabSz="1828937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72E5C7AF-4F83-438E-8466-D51D0829F6C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509225" y="4930982"/>
              <a:ext cx="3076455" cy="254989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2871" tIns="91435" rIns="182871" bIns="91435" anchor="ctr"/>
            <a:lstStyle/>
            <a:p>
              <a:pPr algn="ctr" defTabSz="1828937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11"/>
          <p:cNvGrpSpPr>
            <a:grpSpLocks/>
          </p:cNvGrpSpPr>
          <p:nvPr userDrawn="1"/>
        </p:nvGrpSpPr>
        <p:grpSpPr bwMode="auto">
          <a:xfrm>
            <a:off x="404813" y="7812088"/>
            <a:ext cx="13181012" cy="5449887"/>
            <a:chOff x="405184" y="7811301"/>
            <a:chExt cx="13180496" cy="5450723"/>
          </a:xfrm>
        </p:grpSpPr>
        <p:grpSp>
          <p:nvGrpSpPr>
            <p:cNvPr id="8" name="그룹 12"/>
            <p:cNvGrpSpPr>
              <a:grpSpLocks/>
            </p:cNvGrpSpPr>
            <p:nvPr/>
          </p:nvGrpSpPr>
          <p:grpSpPr bwMode="auto">
            <a:xfrm>
              <a:off x="405184" y="7811301"/>
              <a:ext cx="13180496" cy="5450723"/>
              <a:chOff x="405184" y="7811301"/>
              <a:chExt cx="13180496" cy="5450723"/>
            </a:xfrm>
          </p:grpSpPr>
          <p:sp>
            <p:nvSpPr>
              <p:cNvPr id="10" name="직사각형 9">
                <a:extLst>
                  <a:ext uri="{FF2B5EF4-FFF2-40B4-BE49-F238E27FC236}">
                    <a16:creationId xmlns:a16="http://schemas.microsoft.com/office/drawing/2014/main" id="{B5E61C1D-6B8C-4768-BDDE-D5E609568DC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05184" y="7811301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직사각형 10">
                <a:extLst>
                  <a:ext uri="{FF2B5EF4-FFF2-40B4-BE49-F238E27FC236}">
                    <a16:creationId xmlns:a16="http://schemas.microsoft.com/office/drawing/2014/main" id="{78A7166D-D14C-4EA6-A87F-D3C8935F593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76902" y="7811301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직사각형 11">
                <a:extLst>
                  <a:ext uri="{FF2B5EF4-FFF2-40B4-BE49-F238E27FC236}">
                    <a16:creationId xmlns:a16="http://schemas.microsoft.com/office/drawing/2014/main" id="{906313FE-94D2-47D0-9543-D1AB4B5A23A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143857" y="7811301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직사각형 12">
                <a:extLst>
                  <a:ext uri="{FF2B5EF4-FFF2-40B4-BE49-F238E27FC236}">
                    <a16:creationId xmlns:a16="http://schemas.microsoft.com/office/drawing/2014/main" id="{65903D43-9944-4A3D-B8B5-3439E4F19F8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0509225" y="7811301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286BB314-4008-4117-ABE3-405F4728012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05184" y="10712108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DE8DEC47-8CDB-4C3A-B267-0EB9BD87429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776902" y="10712108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직사각형 15">
                <a:extLst>
                  <a:ext uri="{FF2B5EF4-FFF2-40B4-BE49-F238E27FC236}">
                    <a16:creationId xmlns:a16="http://schemas.microsoft.com/office/drawing/2014/main" id="{5509F1F5-E8A1-4E0D-BB9C-87A34870967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143857" y="10712108"/>
                <a:ext cx="3076455" cy="25499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2871" tIns="91435" rIns="182871" bIns="91435" anchor="ctr"/>
              <a:lstStyle/>
              <a:p>
                <a:pPr algn="ctr" defTabSz="1828937" eaLnBrk="1" fontAlgn="auto" latinLnBrk="1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ko-KR" altLang="en-US" sz="2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D1562DBD-3EFE-41D1-9A0F-692B42155E4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509225" y="10712108"/>
              <a:ext cx="3076455" cy="254991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2871" tIns="91435" rIns="182871" bIns="91435" anchor="ctr"/>
            <a:lstStyle/>
            <a:p>
              <a:pPr algn="ctr" defTabSz="1828937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21173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081213" y="6723702"/>
            <a:ext cx="9607076" cy="19010967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0916914" y="6723702"/>
            <a:ext cx="9607076" cy="19010967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12C32A-BDB6-4AEF-B4B0-50F45BE89A0E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73E5E3-8FB2-4707-8144-53D73E98ED1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5853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1" y="732497"/>
            <a:ext cx="12345829" cy="304853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85880" y="4094346"/>
            <a:ext cx="6060984" cy="170632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68" indent="0">
              <a:buNone/>
              <a:defRPr sz="4000" b="1"/>
            </a:lvl2pPr>
            <a:lvl3pPr marL="1828937" indent="0">
              <a:buNone/>
              <a:defRPr sz="3600" b="1"/>
            </a:lvl3pPr>
            <a:lvl4pPr marL="2743405" indent="0">
              <a:buNone/>
              <a:defRPr sz="3200" b="1"/>
            </a:lvl4pPr>
            <a:lvl5pPr marL="3657875" indent="0">
              <a:buNone/>
              <a:defRPr sz="3200" b="1"/>
            </a:lvl5pPr>
            <a:lvl6pPr marL="4572343" indent="0">
              <a:buNone/>
              <a:defRPr sz="3200" b="1"/>
            </a:lvl6pPr>
            <a:lvl7pPr marL="5486812" indent="0">
              <a:buNone/>
              <a:defRPr sz="3200" b="1"/>
            </a:lvl7pPr>
            <a:lvl8pPr marL="6401280" indent="0">
              <a:buNone/>
              <a:defRPr sz="3200" b="1"/>
            </a:lvl8pPr>
            <a:lvl9pPr marL="7315748" indent="0">
              <a:buNone/>
              <a:defRPr sz="3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85880" y="5800675"/>
            <a:ext cx="6060984" cy="10538597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968346" y="4094346"/>
            <a:ext cx="6063364" cy="170632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68" indent="0">
              <a:buNone/>
              <a:defRPr sz="4000" b="1"/>
            </a:lvl2pPr>
            <a:lvl3pPr marL="1828937" indent="0">
              <a:buNone/>
              <a:defRPr sz="3600" b="1"/>
            </a:lvl3pPr>
            <a:lvl4pPr marL="2743405" indent="0">
              <a:buNone/>
              <a:defRPr sz="3200" b="1"/>
            </a:lvl4pPr>
            <a:lvl5pPr marL="3657875" indent="0">
              <a:buNone/>
              <a:defRPr sz="3200" b="1"/>
            </a:lvl5pPr>
            <a:lvl6pPr marL="4572343" indent="0">
              <a:buNone/>
              <a:defRPr sz="3200" b="1"/>
            </a:lvl6pPr>
            <a:lvl7pPr marL="5486812" indent="0">
              <a:buNone/>
              <a:defRPr sz="3200" b="1"/>
            </a:lvl7pPr>
            <a:lvl8pPr marL="6401280" indent="0">
              <a:buNone/>
              <a:defRPr sz="3200" b="1"/>
            </a:lvl8pPr>
            <a:lvl9pPr marL="7315748" indent="0">
              <a:buNone/>
              <a:defRPr sz="3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968346" y="5800675"/>
            <a:ext cx="6063364" cy="10538597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AB81A2-400D-4CA1-9865-24B7A9110B73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8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13CD9F-A288-4C78-AAAB-6CB15664DB36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816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E35DB6-7D55-4CF8-855A-38E65ACB6F48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4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97FEE8-8B2C-4215-AEB3-E655BBFFB68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989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85593C-08DA-4495-83A4-7A75387BEE37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3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C4E603-1D18-44F3-AAA9-1995A5AB644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46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1" y="728263"/>
            <a:ext cx="4512992" cy="3099338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363197" y="728262"/>
            <a:ext cx="7668512" cy="15611011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85881" y="3827599"/>
            <a:ext cx="4512992" cy="12511673"/>
          </a:xfrm>
        </p:spPr>
        <p:txBody>
          <a:bodyPr/>
          <a:lstStyle>
            <a:lvl1pPr marL="0" indent="0">
              <a:buNone/>
              <a:defRPr sz="2800"/>
            </a:lvl1pPr>
            <a:lvl2pPr marL="914468" indent="0">
              <a:buNone/>
              <a:defRPr sz="2400"/>
            </a:lvl2pPr>
            <a:lvl3pPr marL="1828937" indent="0">
              <a:buNone/>
              <a:defRPr sz="2000"/>
            </a:lvl3pPr>
            <a:lvl4pPr marL="2743405" indent="0">
              <a:buNone/>
              <a:defRPr sz="1800"/>
            </a:lvl4pPr>
            <a:lvl5pPr marL="3657875" indent="0">
              <a:buNone/>
              <a:defRPr sz="1800"/>
            </a:lvl5pPr>
            <a:lvl6pPr marL="4572343" indent="0">
              <a:buNone/>
              <a:defRPr sz="1800"/>
            </a:lvl6pPr>
            <a:lvl7pPr marL="5486812" indent="0">
              <a:buNone/>
              <a:defRPr sz="1800"/>
            </a:lvl7pPr>
            <a:lvl8pPr marL="6401280" indent="0">
              <a:buNone/>
              <a:defRPr sz="1800"/>
            </a:lvl8pPr>
            <a:lvl9pPr marL="7315748" indent="0">
              <a:buNone/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E40950-29FE-4252-AB4F-BDDE6CDF4D24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6645-D6DF-4DF7-ACCF-518D551D5F1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291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688744" y="12803821"/>
            <a:ext cx="8230553" cy="1511564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688744" y="1634351"/>
            <a:ext cx="8230553" cy="10974705"/>
          </a:xfrm>
        </p:spPr>
        <p:txBody>
          <a:bodyPr rtlCol="0">
            <a:normAutofit/>
          </a:bodyPr>
          <a:lstStyle>
            <a:lvl1pPr marL="0" indent="0">
              <a:buNone/>
              <a:defRPr sz="6400"/>
            </a:lvl1pPr>
            <a:lvl2pPr marL="914468" indent="0">
              <a:buNone/>
              <a:defRPr sz="5600"/>
            </a:lvl2pPr>
            <a:lvl3pPr marL="1828937" indent="0">
              <a:buNone/>
              <a:defRPr sz="4800"/>
            </a:lvl3pPr>
            <a:lvl4pPr marL="2743405" indent="0">
              <a:buNone/>
              <a:defRPr sz="4000"/>
            </a:lvl4pPr>
            <a:lvl5pPr marL="3657875" indent="0">
              <a:buNone/>
              <a:defRPr sz="4000"/>
            </a:lvl5pPr>
            <a:lvl6pPr marL="4572343" indent="0">
              <a:buNone/>
              <a:defRPr sz="4000"/>
            </a:lvl6pPr>
            <a:lvl7pPr marL="5486812" indent="0">
              <a:buNone/>
              <a:defRPr sz="4000"/>
            </a:lvl7pPr>
            <a:lvl8pPr marL="6401280" indent="0">
              <a:buNone/>
              <a:defRPr sz="4000"/>
            </a:lvl8pPr>
            <a:lvl9pPr marL="7315748" indent="0">
              <a:buNone/>
              <a:defRPr sz="4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688744" y="14315385"/>
            <a:ext cx="8230553" cy="2146672"/>
          </a:xfrm>
        </p:spPr>
        <p:txBody>
          <a:bodyPr/>
          <a:lstStyle>
            <a:lvl1pPr marL="0" indent="0">
              <a:buNone/>
              <a:defRPr sz="2800"/>
            </a:lvl1pPr>
            <a:lvl2pPr marL="914468" indent="0">
              <a:buNone/>
              <a:defRPr sz="2400"/>
            </a:lvl2pPr>
            <a:lvl3pPr marL="1828937" indent="0">
              <a:buNone/>
              <a:defRPr sz="2000"/>
            </a:lvl3pPr>
            <a:lvl4pPr marL="2743405" indent="0">
              <a:buNone/>
              <a:defRPr sz="1800"/>
            </a:lvl4pPr>
            <a:lvl5pPr marL="3657875" indent="0">
              <a:buNone/>
              <a:defRPr sz="1800"/>
            </a:lvl5pPr>
            <a:lvl6pPr marL="4572343" indent="0">
              <a:buNone/>
              <a:defRPr sz="1800"/>
            </a:lvl6pPr>
            <a:lvl7pPr marL="5486812" indent="0">
              <a:buNone/>
              <a:defRPr sz="1800"/>
            </a:lvl7pPr>
            <a:lvl8pPr marL="6401280" indent="0">
              <a:buNone/>
              <a:defRPr sz="1800"/>
            </a:lvl8pPr>
            <a:lvl9pPr marL="7315748" indent="0">
              <a:buNone/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8CB282-8663-4055-B9F5-375F51E1CE57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6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1669AA-0C28-4691-BB94-F8F4E164537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8872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85800" y="731838"/>
            <a:ext cx="12345988" cy="3049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82893" tIns="91447" rIns="182893" bIns="91447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85800" y="4267200"/>
            <a:ext cx="12345988" cy="12071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82893" tIns="91447" rIns="182893" bIns="91447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974338-50DE-4708-8DDE-21B1291561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5800" y="16952913"/>
            <a:ext cx="3200400" cy="974725"/>
          </a:xfrm>
          <a:prstGeom prst="rect">
            <a:avLst/>
          </a:prstGeom>
        </p:spPr>
        <p:txBody>
          <a:bodyPr vert="horz" lIns="182893" tIns="91447" rIns="182893" bIns="91447" rtlCol="0" anchor="ctr"/>
          <a:lstStyle>
            <a:lvl1pPr algn="l" defTabSz="1828937" eaLnBrk="1" fontAlgn="auto" latinLnBrk="1" hangingPunct="1">
              <a:spcBef>
                <a:spcPts val="0"/>
              </a:spcBef>
              <a:spcAft>
                <a:spcPts val="0"/>
              </a:spcAft>
              <a:defRPr kumimoji="0" sz="24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D015EC3-ED71-4AC2-A128-94F7521B9A3C}" type="datetimeFigureOut">
              <a:rPr lang="ko-KR" altLang="en-US"/>
              <a:pPr>
                <a:defRPr/>
              </a:pPr>
              <a:t>2020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B3E4DB-C8D3-4B90-B045-4191341D37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686300" y="16952913"/>
            <a:ext cx="4344988" cy="974725"/>
          </a:xfrm>
          <a:prstGeom prst="rect">
            <a:avLst/>
          </a:prstGeom>
        </p:spPr>
        <p:txBody>
          <a:bodyPr vert="horz" lIns="182893" tIns="91447" rIns="182893" bIns="91447" rtlCol="0" anchor="ctr"/>
          <a:lstStyle>
            <a:lvl1pPr algn="ctr" defTabSz="1828937" eaLnBrk="1" fontAlgn="auto" latinLnBrk="1" hangingPunct="1">
              <a:spcBef>
                <a:spcPts val="0"/>
              </a:spcBef>
              <a:spcAft>
                <a:spcPts val="0"/>
              </a:spcAft>
              <a:defRPr kumimoji="0" sz="24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014F81-8F5F-470C-AAB7-3A99CB0200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9831388" y="16952913"/>
            <a:ext cx="3200400" cy="974725"/>
          </a:xfrm>
          <a:prstGeom prst="rect">
            <a:avLst/>
          </a:prstGeom>
        </p:spPr>
        <p:txBody>
          <a:bodyPr vert="horz" wrap="square" lIns="182893" tIns="91447" rIns="182893" bIns="91447" numCol="1" anchor="ctr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2400">
                <a:solidFill>
                  <a:srgbClr val="898989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</a:lstStyle>
          <a:p>
            <a:pPr>
              <a:defRPr/>
            </a:pPr>
            <a:fld id="{320371AB-CE0F-43C1-BA70-AF5CC41F2AB7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9213" r:id="rId1"/>
    <p:sldLayoutId id="2147489222" r:id="rId2"/>
    <p:sldLayoutId id="2147489223" r:id="rId3"/>
    <p:sldLayoutId id="2147489214" r:id="rId4"/>
    <p:sldLayoutId id="2147489215" r:id="rId5"/>
    <p:sldLayoutId id="2147489216" r:id="rId6"/>
    <p:sldLayoutId id="2147489217" r:id="rId7"/>
    <p:sldLayoutId id="2147489218" r:id="rId8"/>
    <p:sldLayoutId id="2147489219" r:id="rId9"/>
    <p:sldLayoutId id="2147489220" r:id="rId10"/>
    <p:sldLayoutId id="2147489221" r:id="rId11"/>
  </p:sldLayoutIdLst>
  <p:txStyles>
    <p:titleStyle>
      <a:lvl1pPr algn="ctr" defTabSz="1828800" rtl="0" eaLnBrk="0" fontAlgn="base" latinLnBrk="1" hangingPunct="0">
        <a:spcBef>
          <a:spcPct val="0"/>
        </a:spcBef>
        <a:spcAft>
          <a:spcPct val="0"/>
        </a:spcAft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828800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defTabSz="1828800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defTabSz="1828800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defTabSz="1828800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defTabSz="1828800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defTabSz="1828800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defTabSz="1828800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defTabSz="1828800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685800" indent="-685800" algn="l" defTabSz="1828800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1pPr>
      <a:lvl2pPr marL="1485900" indent="-571500" algn="l" defTabSz="1828800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577" indent="-457235" algn="l" defTabSz="1828937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44045" indent="-457235" algn="l" defTabSz="1828937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515" indent="-457235" algn="l" defTabSz="1828937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983" indent="-457235" algn="l" defTabSz="1828937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68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937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405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875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343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812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1280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748" algn="l" defTabSz="1828937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8497515"/>
            <a:ext cx="137175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 Black" panose="020B0A04020102020204" pitchFamily="34" charset="0"/>
              </a:rPr>
              <a:t>Supplementary figures </a:t>
            </a:r>
            <a:endParaRPr lang="ko-KR" altLang="en-US" b="1" dirty="0">
              <a:latin typeface="Arial Black" panose="020B0A04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82970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6466" y="3600971"/>
            <a:ext cx="4578096" cy="81000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1FE1BF-5739-49B6-A03B-AF7537DE2A5D}"/>
              </a:ext>
            </a:extLst>
          </p:cNvPr>
          <p:cNvSpPr txBox="1"/>
          <p:nvPr/>
        </p:nvSpPr>
        <p:spPr>
          <a:xfrm>
            <a:off x="2646326" y="12745987"/>
            <a:ext cx="70567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the immunohistochemica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tissue microarray of periampullar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iampullar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ncers (x400).  (a) Sox2 cytoplasm and nucleus (b) CD24 (c) OCT4 (d) IGF-1 (e) FGFR1, (f)  VEGF (g) CD44v6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CK7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CK20 (j) CDX-2 (k) MUC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negativ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o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),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+ (low expressio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+ (moderate expressio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+ ( high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)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.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4482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>
            <a:extLst>
              <a:ext uri="{FF2B5EF4-FFF2-40B4-BE49-F238E27FC236}">
                <a16:creationId xmlns:a16="http://schemas.microsoft.com/office/drawing/2014/main" id="{7A1FE1BF-5739-49B6-A03B-AF7537DE2A5D}"/>
              </a:ext>
            </a:extLst>
          </p:cNvPr>
          <p:cNvSpPr txBox="1"/>
          <p:nvPr/>
        </p:nvSpPr>
        <p:spPr>
          <a:xfrm>
            <a:off x="2544138" y="14626367"/>
            <a:ext cx="9245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 survival analysis on the relationship between disease fre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and clinical parameter in recurrent 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iampullary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pancreatic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s . 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e was significant difference according to (A) age, (C) location, (D) T stage, (F) Size, and (G) 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ge.Whil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e was no significant difference according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sex, (E)  gross type, and (H) M stage.</a:t>
            </a:r>
          </a:p>
        </p:txBody>
      </p:sp>
      <p:grpSp>
        <p:nvGrpSpPr>
          <p:cNvPr id="137" name="Group 136"/>
          <p:cNvGrpSpPr/>
          <p:nvPr/>
        </p:nvGrpSpPr>
        <p:grpSpPr>
          <a:xfrm>
            <a:off x="2923490" y="714652"/>
            <a:ext cx="8064894" cy="13571314"/>
            <a:chOff x="3671865" y="2271174"/>
            <a:chExt cx="6587097" cy="11084530"/>
          </a:xfrm>
        </p:grpSpPr>
        <p:grpSp>
          <p:nvGrpSpPr>
            <p:cNvPr id="138" name="그룹 92"/>
            <p:cNvGrpSpPr/>
            <p:nvPr/>
          </p:nvGrpSpPr>
          <p:grpSpPr>
            <a:xfrm>
              <a:off x="3671865" y="2271174"/>
              <a:ext cx="6587097" cy="11084530"/>
              <a:chOff x="3052131" y="2224986"/>
              <a:chExt cx="6587097" cy="11084530"/>
            </a:xfrm>
          </p:grpSpPr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10ED5E60-BEBB-4AD2-B113-7B834F4DB424}"/>
                  </a:ext>
                </a:extLst>
              </p:cNvPr>
              <p:cNvSpPr txBox="1"/>
              <p:nvPr/>
            </p:nvSpPr>
            <p:spPr>
              <a:xfrm>
                <a:off x="3052131" y="2237048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A.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0A4146DC-4497-4450-B452-49B8FA9BA704}"/>
                  </a:ext>
                </a:extLst>
              </p:cNvPr>
              <p:cNvSpPr txBox="1"/>
              <p:nvPr/>
            </p:nvSpPr>
            <p:spPr>
              <a:xfrm>
                <a:off x="6397057" y="2224986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B.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15C90AE8-1BF2-4399-A383-F4F9BA99CB63}"/>
                  </a:ext>
                </a:extLst>
              </p:cNvPr>
              <p:cNvSpPr txBox="1"/>
              <p:nvPr/>
            </p:nvSpPr>
            <p:spPr>
              <a:xfrm>
                <a:off x="3071998" y="5037109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C.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8421C2DF-CFC3-4846-AECE-1BE7B1996054}"/>
                  </a:ext>
                </a:extLst>
              </p:cNvPr>
              <p:cNvSpPr txBox="1"/>
              <p:nvPr/>
            </p:nvSpPr>
            <p:spPr>
              <a:xfrm>
                <a:off x="6426746" y="5041887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D.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39FFDA67-38E6-42AE-87F4-F5F3965D5D7F}"/>
                  </a:ext>
                </a:extLst>
              </p:cNvPr>
              <p:cNvSpPr txBox="1"/>
              <p:nvPr/>
            </p:nvSpPr>
            <p:spPr>
              <a:xfrm>
                <a:off x="3081415" y="7921451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E.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6B67F517-86E4-4BD6-B6EE-D357CC46F37B}"/>
                  </a:ext>
                </a:extLst>
              </p:cNvPr>
              <p:cNvSpPr txBox="1"/>
              <p:nvPr/>
            </p:nvSpPr>
            <p:spPr>
              <a:xfrm>
                <a:off x="6436689" y="7931784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F.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AAC337B8-92AA-4A5E-9D11-26ED14576443}"/>
                  </a:ext>
                </a:extLst>
              </p:cNvPr>
              <p:cNvSpPr txBox="1"/>
              <p:nvPr/>
            </p:nvSpPr>
            <p:spPr>
              <a:xfrm>
                <a:off x="3081415" y="10729421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G.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9EF7EE1A-D830-405A-B220-FDC47D670C2C}"/>
                  </a:ext>
                </a:extLst>
              </p:cNvPr>
              <p:cNvSpPr txBox="1"/>
              <p:nvPr/>
            </p:nvSpPr>
            <p:spPr>
              <a:xfrm>
                <a:off x="6405066" y="10734485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H.</a:t>
                </a: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8761981" y="2463722"/>
                <a:ext cx="412185" cy="1871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ko-KR" altLang="en-US" dirty="0"/>
              </a:p>
            </p:txBody>
          </p:sp>
          <p:grpSp>
            <p:nvGrpSpPr>
              <p:cNvPr id="231" name="그룹 168"/>
              <p:cNvGrpSpPr/>
              <p:nvPr/>
            </p:nvGrpSpPr>
            <p:grpSpPr>
              <a:xfrm>
                <a:off x="6648265" y="2315682"/>
                <a:ext cx="2980185" cy="2492239"/>
                <a:chOff x="6657685" y="2299680"/>
                <a:chExt cx="2980185" cy="2492239"/>
              </a:xfrm>
            </p:grpSpPr>
            <p:grpSp>
              <p:nvGrpSpPr>
                <p:cNvPr id="279" name="그룹 216"/>
                <p:cNvGrpSpPr/>
                <p:nvPr/>
              </p:nvGrpSpPr>
              <p:grpSpPr>
                <a:xfrm>
                  <a:off x="6657685" y="2299680"/>
                  <a:ext cx="2980185" cy="2492239"/>
                  <a:chOff x="6657685" y="2299680"/>
                  <a:chExt cx="2980185" cy="2492239"/>
                </a:xfrm>
              </p:grpSpPr>
              <p:grpSp>
                <p:nvGrpSpPr>
                  <p:cNvPr id="281" name="그룹 218"/>
                  <p:cNvGrpSpPr/>
                  <p:nvPr/>
                </p:nvGrpSpPr>
                <p:grpSpPr>
                  <a:xfrm>
                    <a:off x="6657685" y="2299680"/>
                    <a:ext cx="2980185" cy="2492239"/>
                    <a:chOff x="8871787" y="5485767"/>
                    <a:chExt cx="2980185" cy="2492239"/>
                  </a:xfrm>
                </p:grpSpPr>
                <p:pic>
                  <p:nvPicPr>
                    <p:cNvPr id="283" name="Picture 3">
                      <a:extLst>
                        <a:ext uri="{FF2B5EF4-FFF2-40B4-BE49-F238E27FC236}">
                          <a16:creationId xmlns:a16="http://schemas.microsoft.com/office/drawing/2014/main" id="{57103077-8F82-4ABD-9F13-F46BEB77D62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4831"/>
                    <a:stretch/>
                  </p:blipFill>
                  <p:spPr>
                    <a:xfrm>
                      <a:off x="8871787" y="5485767"/>
                      <a:ext cx="2980185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84" name="TextBox 283">
                      <a:extLst>
                        <a:ext uri="{FF2B5EF4-FFF2-40B4-BE49-F238E27FC236}">
                          <a16:creationId xmlns:a16="http://schemas.microsoft.com/office/drawing/2014/main" id="{CE19126B-4A78-42B1-93DF-60738C11D5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227915" y="6151666"/>
                      <a:ext cx="549598" cy="276999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 Black" panose="020B0A04020102020204" pitchFamily="34" charset="0"/>
                        </a:rPr>
                        <a:t>Sex </a:t>
                      </a:r>
                    </a:p>
                  </p:txBody>
                </p:sp>
              </p:grpSp>
              <p:sp>
                <p:nvSpPr>
                  <p:cNvPr id="282" name="TextBox 281"/>
                  <p:cNvSpPr txBox="1"/>
                  <p:nvPr/>
                </p:nvSpPr>
                <p:spPr>
                  <a:xfrm>
                    <a:off x="8746278" y="2417002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80" name="TextBox 279"/>
                <p:cNvSpPr txBox="1"/>
                <p:nvPr/>
              </p:nvSpPr>
              <p:spPr>
                <a:xfrm>
                  <a:off x="8790100" y="2362658"/>
                  <a:ext cx="76650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955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2" name="그룹 169"/>
              <p:cNvGrpSpPr/>
              <p:nvPr/>
            </p:nvGrpSpPr>
            <p:grpSpPr>
              <a:xfrm>
                <a:off x="3370523" y="10797509"/>
                <a:ext cx="2980185" cy="2506308"/>
                <a:chOff x="3370523" y="10802504"/>
                <a:chExt cx="2980185" cy="2506308"/>
              </a:xfrm>
            </p:grpSpPr>
            <p:grpSp>
              <p:nvGrpSpPr>
                <p:cNvPr id="273" name="그룹 210"/>
                <p:cNvGrpSpPr/>
                <p:nvPr/>
              </p:nvGrpSpPr>
              <p:grpSpPr>
                <a:xfrm>
                  <a:off x="3370523" y="10802504"/>
                  <a:ext cx="2980185" cy="2506308"/>
                  <a:chOff x="3370523" y="10802504"/>
                  <a:chExt cx="2980185" cy="2506308"/>
                </a:xfrm>
              </p:grpSpPr>
              <p:grpSp>
                <p:nvGrpSpPr>
                  <p:cNvPr id="275" name="그룹 212"/>
                  <p:cNvGrpSpPr/>
                  <p:nvPr/>
                </p:nvGrpSpPr>
                <p:grpSpPr>
                  <a:xfrm>
                    <a:off x="3370523" y="10802504"/>
                    <a:ext cx="2980185" cy="2506308"/>
                    <a:chOff x="7981410" y="12187020"/>
                    <a:chExt cx="5722309" cy="4464496"/>
                  </a:xfrm>
                </p:grpSpPr>
                <p:pic>
                  <p:nvPicPr>
                    <p:cNvPr id="277" name="그림 214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45" t="2649" r="-945" b="15235"/>
                    <a:stretch/>
                  </p:blipFill>
                  <p:spPr>
                    <a:xfrm>
                      <a:off x="7981410" y="12187020"/>
                      <a:ext cx="5722309" cy="446449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78" name="TextBox 277">
                      <a:extLst>
                        <a:ext uri="{FF2B5EF4-FFF2-40B4-BE49-F238E27FC236}">
                          <a16:creationId xmlns:a16="http://schemas.microsoft.com/office/drawing/2014/main" id="{CE19126B-4A78-42B1-93DF-60738C11D5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238423" y="13462077"/>
                      <a:ext cx="1658270" cy="493419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 Black" panose="020B0A04020102020204" pitchFamily="34" charset="0"/>
                        </a:rPr>
                        <a:t>N stage</a:t>
                      </a:r>
                    </a:p>
                  </p:txBody>
                </p:sp>
              </p:grpSp>
              <p:sp>
                <p:nvSpPr>
                  <p:cNvPr id="276" name="TextBox 275"/>
                  <p:cNvSpPr txBox="1"/>
                  <p:nvPr/>
                </p:nvSpPr>
                <p:spPr>
                  <a:xfrm>
                    <a:off x="5400003" y="10963542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74" name="TextBox 273"/>
                <p:cNvSpPr txBox="1"/>
                <p:nvPr/>
              </p:nvSpPr>
              <p:spPr>
                <a:xfrm>
                  <a:off x="5238552" y="10896710"/>
                  <a:ext cx="98406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00391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3" name="그룹 170"/>
              <p:cNvGrpSpPr/>
              <p:nvPr/>
            </p:nvGrpSpPr>
            <p:grpSpPr>
              <a:xfrm>
                <a:off x="3377477" y="2306692"/>
                <a:ext cx="2980185" cy="2492240"/>
                <a:chOff x="3377477" y="2311687"/>
                <a:chExt cx="2980185" cy="2492240"/>
              </a:xfrm>
            </p:grpSpPr>
            <p:grpSp>
              <p:nvGrpSpPr>
                <p:cNvPr id="268" name="그룹 205"/>
                <p:cNvGrpSpPr/>
                <p:nvPr/>
              </p:nvGrpSpPr>
              <p:grpSpPr>
                <a:xfrm>
                  <a:off x="3377477" y="2311687"/>
                  <a:ext cx="2980185" cy="2492240"/>
                  <a:chOff x="3383096" y="2290305"/>
                  <a:chExt cx="2980185" cy="2492240"/>
                </a:xfrm>
              </p:grpSpPr>
              <p:pic>
                <p:nvPicPr>
                  <p:cNvPr id="271" name="Picture 2">
                    <a:extLst>
                      <a:ext uri="{FF2B5EF4-FFF2-40B4-BE49-F238E27FC236}">
                        <a16:creationId xmlns:a16="http://schemas.microsoft.com/office/drawing/2014/main" id="{208813E3-F7AD-443D-8961-1003B787F11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3150" b="14965"/>
                  <a:stretch/>
                </p:blipFill>
                <p:spPr>
                  <a:xfrm>
                    <a:off x="3383096" y="2290305"/>
                    <a:ext cx="2980185" cy="2492240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272" name="TextBox 271"/>
                  <p:cNvSpPr txBox="1"/>
                  <p:nvPr/>
                </p:nvSpPr>
                <p:spPr>
                  <a:xfrm>
                    <a:off x="5466098" y="2417002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69" name="TextBox 268"/>
                <p:cNvSpPr txBox="1"/>
                <p:nvPr/>
              </p:nvSpPr>
              <p:spPr>
                <a:xfrm>
                  <a:off x="5381978" y="2387833"/>
                  <a:ext cx="852385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221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  <p:sp>
              <p:nvSpPr>
                <p:cNvPr id="270" name="TextBox 269">
                  <a:extLst>
                    <a:ext uri="{FF2B5EF4-FFF2-40B4-BE49-F238E27FC236}">
                      <a16:creationId xmlns:a16="http://schemas.microsoft.com/office/drawing/2014/main" id="{95230834-C4B6-45C5-A88B-C8A49CA6C558}"/>
                    </a:ext>
                  </a:extLst>
                </p:cNvPr>
                <p:cNvSpPr txBox="1"/>
                <p:nvPr/>
              </p:nvSpPr>
              <p:spPr>
                <a:xfrm>
                  <a:off x="4578643" y="3005744"/>
                  <a:ext cx="717493" cy="246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Age&gt;74</a:t>
                  </a:r>
                </a:p>
              </p:txBody>
            </p:sp>
          </p:grpSp>
          <p:grpSp>
            <p:nvGrpSpPr>
              <p:cNvPr id="234" name="그룹 171"/>
              <p:cNvGrpSpPr/>
              <p:nvPr/>
            </p:nvGrpSpPr>
            <p:grpSpPr>
              <a:xfrm>
                <a:off x="3362427" y="5115789"/>
                <a:ext cx="2980185" cy="2492239"/>
                <a:chOff x="3362427" y="5120784"/>
                <a:chExt cx="2980185" cy="2492239"/>
              </a:xfrm>
            </p:grpSpPr>
            <p:grpSp>
              <p:nvGrpSpPr>
                <p:cNvPr id="263" name="그룹 200"/>
                <p:cNvGrpSpPr/>
                <p:nvPr/>
              </p:nvGrpSpPr>
              <p:grpSpPr>
                <a:xfrm>
                  <a:off x="3362427" y="5120784"/>
                  <a:ext cx="2980185" cy="2492239"/>
                  <a:chOff x="3377639" y="5153264"/>
                  <a:chExt cx="2980185" cy="2492239"/>
                </a:xfrm>
              </p:grpSpPr>
              <p:pic>
                <p:nvPicPr>
                  <p:cNvPr id="266" name="Picture 7">
                    <a:extLst>
                      <a:ext uri="{FF2B5EF4-FFF2-40B4-BE49-F238E27FC236}">
                        <a16:creationId xmlns:a16="http://schemas.microsoft.com/office/drawing/2014/main" id="{96632B01-1376-4EE3-8318-26E9A09F223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032" b="14555"/>
                  <a:stretch/>
                </p:blipFill>
                <p:spPr>
                  <a:xfrm>
                    <a:off x="3377639" y="5153264"/>
                    <a:ext cx="2980185" cy="2492239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sp>
                <p:nvSpPr>
                  <p:cNvPr id="267" name="TextBox 266"/>
                  <p:cNvSpPr txBox="1"/>
                  <p:nvPr/>
                </p:nvSpPr>
                <p:spPr>
                  <a:xfrm>
                    <a:off x="5463569" y="5191286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64" name="TextBox 263">
                  <a:extLst>
                    <a:ext uri="{FF2B5EF4-FFF2-40B4-BE49-F238E27FC236}">
                      <a16:creationId xmlns:a16="http://schemas.microsoft.com/office/drawing/2014/main" id="{A9E65EF3-E210-4BD2-AE8A-C47DE43BE763}"/>
                    </a:ext>
                  </a:extLst>
                </p:cNvPr>
                <p:cNvSpPr txBox="1"/>
                <p:nvPr/>
              </p:nvSpPr>
              <p:spPr>
                <a:xfrm>
                  <a:off x="4118382" y="5619843"/>
                  <a:ext cx="1628853" cy="40011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 Black" panose="020B0A04020102020204" pitchFamily="34" charset="0"/>
                      <a:cs typeface="Arial" panose="020B0604020202020204" pitchFamily="34" charset="0"/>
                    </a:rPr>
                    <a:t>Location</a:t>
                  </a:r>
                </a:p>
                <a:p>
                  <a:pPr algn="ctr"/>
                  <a:r>
                    <a:rPr lang="en-US" sz="1000" b="1" dirty="0" smtClean="0">
                      <a:latin typeface="Arial Black" panose="020B0A04020102020204" pitchFamily="34" charset="0"/>
                      <a:cs typeface="Arial" panose="020B0604020202020204" pitchFamily="34" charset="0"/>
                    </a:rPr>
                    <a:t>Pancreas&lt;CBD&lt;AOV</a:t>
                  </a:r>
                  <a:endParaRPr lang="en-US" sz="1000" b="1" dirty="0">
                    <a:latin typeface="Arial Black" panose="020B0A040201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5" name="TextBox 264"/>
                <p:cNvSpPr txBox="1"/>
                <p:nvPr/>
              </p:nvSpPr>
              <p:spPr>
                <a:xfrm>
                  <a:off x="5446340" y="5140899"/>
                  <a:ext cx="74422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14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5" name="그룹 172"/>
              <p:cNvGrpSpPr/>
              <p:nvPr/>
            </p:nvGrpSpPr>
            <p:grpSpPr>
              <a:xfrm>
                <a:off x="6659043" y="5131915"/>
                <a:ext cx="2980185" cy="2492239"/>
                <a:chOff x="6678211" y="5127160"/>
                <a:chExt cx="2980185" cy="2492239"/>
              </a:xfrm>
            </p:grpSpPr>
            <p:grpSp>
              <p:nvGrpSpPr>
                <p:cNvPr id="257" name="그룹 194"/>
                <p:cNvGrpSpPr/>
                <p:nvPr/>
              </p:nvGrpSpPr>
              <p:grpSpPr>
                <a:xfrm>
                  <a:off x="6678211" y="5127160"/>
                  <a:ext cx="2980185" cy="2492239"/>
                  <a:chOff x="6678211" y="5127160"/>
                  <a:chExt cx="2980185" cy="2492239"/>
                </a:xfrm>
              </p:grpSpPr>
              <p:grpSp>
                <p:nvGrpSpPr>
                  <p:cNvPr id="259" name="그룹 196"/>
                  <p:cNvGrpSpPr/>
                  <p:nvPr/>
                </p:nvGrpSpPr>
                <p:grpSpPr>
                  <a:xfrm>
                    <a:off x="6678211" y="5127160"/>
                    <a:ext cx="2980185" cy="2492239"/>
                    <a:chOff x="2402396" y="7336565"/>
                    <a:chExt cx="7621736" cy="4522573"/>
                  </a:xfrm>
                </p:grpSpPr>
                <p:pic>
                  <p:nvPicPr>
                    <p:cNvPr id="261" name="그림 198"/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014" b="15155"/>
                    <a:stretch/>
                  </p:blipFill>
                  <p:spPr>
                    <a:xfrm>
                      <a:off x="2402396" y="7336565"/>
                      <a:ext cx="7621736" cy="4522573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62" name="TextBox 261">
                      <a:extLst>
                        <a:ext uri="{FF2B5EF4-FFF2-40B4-BE49-F238E27FC236}">
                          <a16:creationId xmlns:a16="http://schemas.microsoft.com/office/drawing/2014/main" id="{CE19126B-4A78-42B1-93DF-60738C11D5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17299" y="8444010"/>
                      <a:ext cx="2580322" cy="511584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 Black" panose="020B0A04020102020204" pitchFamily="34" charset="0"/>
                        </a:rPr>
                        <a:t>T Stage</a:t>
                      </a:r>
                    </a:p>
                  </p:txBody>
                </p:sp>
              </p:grpSp>
              <p:sp>
                <p:nvSpPr>
                  <p:cNvPr id="260" name="TextBox 259"/>
                  <p:cNvSpPr txBox="1"/>
                  <p:nvPr/>
                </p:nvSpPr>
                <p:spPr>
                  <a:xfrm>
                    <a:off x="8735625" y="5255130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58" name="TextBox 257"/>
                <p:cNvSpPr txBox="1"/>
                <p:nvPr/>
              </p:nvSpPr>
              <p:spPr>
                <a:xfrm>
                  <a:off x="8885604" y="5207091"/>
                  <a:ext cx="65835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2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6" name="그룹 173"/>
              <p:cNvGrpSpPr/>
              <p:nvPr/>
            </p:nvGrpSpPr>
            <p:grpSpPr>
              <a:xfrm>
                <a:off x="6713297" y="7999670"/>
                <a:ext cx="2914293" cy="2492239"/>
                <a:chOff x="6713297" y="8004665"/>
                <a:chExt cx="2914293" cy="2492239"/>
              </a:xfrm>
            </p:grpSpPr>
            <p:grpSp>
              <p:nvGrpSpPr>
                <p:cNvPr id="251" name="그룹 188"/>
                <p:cNvGrpSpPr/>
                <p:nvPr/>
              </p:nvGrpSpPr>
              <p:grpSpPr>
                <a:xfrm>
                  <a:off x="6713297" y="8004665"/>
                  <a:ext cx="2914293" cy="2492239"/>
                  <a:chOff x="6741363" y="9334317"/>
                  <a:chExt cx="2914293" cy="2492239"/>
                </a:xfrm>
              </p:grpSpPr>
              <p:grpSp>
                <p:nvGrpSpPr>
                  <p:cNvPr id="253" name="그룹 190"/>
                  <p:cNvGrpSpPr/>
                  <p:nvPr/>
                </p:nvGrpSpPr>
                <p:grpSpPr>
                  <a:xfrm>
                    <a:off x="6741363" y="9334317"/>
                    <a:ext cx="2914293" cy="2492239"/>
                    <a:chOff x="6734354" y="8006522"/>
                    <a:chExt cx="2914293" cy="2492239"/>
                  </a:xfrm>
                </p:grpSpPr>
                <p:pic>
                  <p:nvPicPr>
                    <p:cNvPr id="255" name="그림 192"/>
                    <p:cNvPicPr>
                      <a:picLocks noChangeAspect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211" t="2713" b="15172"/>
                    <a:stretch/>
                  </p:blipFill>
                  <p:spPr>
                    <a:xfrm>
                      <a:off x="6734354" y="8006522"/>
                      <a:ext cx="2914293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56" name="TextBox 255"/>
                    <p:cNvSpPr txBox="1"/>
                    <p:nvPr/>
                  </p:nvSpPr>
                  <p:spPr>
                    <a:xfrm>
                      <a:off x="8781278" y="8120075"/>
                      <a:ext cx="564453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ko-KR" altLang="en-US" sz="1200" dirty="0"/>
                    </a:p>
                  </p:txBody>
                </p:sp>
              </p:grpSp>
              <p:sp>
                <p:nvSpPr>
                  <p:cNvPr id="254" name="TextBox 253">
                    <a:extLst>
                      <a:ext uri="{FF2B5EF4-FFF2-40B4-BE49-F238E27FC236}">
                        <a16:creationId xmlns:a16="http://schemas.microsoft.com/office/drawing/2014/main" id="{02A5B66A-6FC7-453B-B731-79C5B000B80E}"/>
                      </a:ext>
                    </a:extLst>
                  </p:cNvPr>
                  <p:cNvSpPr txBox="1"/>
                  <p:nvPr/>
                </p:nvSpPr>
                <p:spPr>
                  <a:xfrm>
                    <a:off x="8032459" y="10053170"/>
                    <a:ext cx="478878" cy="24622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Size</a:t>
                    </a:r>
                    <a:endParaRPr lang="en-US" sz="1000" b="1" dirty="0">
                      <a:latin typeface="Arial Black" panose="020B0A040201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52" name="TextBox 251"/>
                <p:cNvSpPr txBox="1"/>
                <p:nvPr/>
              </p:nvSpPr>
              <p:spPr>
                <a:xfrm>
                  <a:off x="8700808" y="8054340"/>
                  <a:ext cx="821227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426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7" name="그룹 174"/>
              <p:cNvGrpSpPr/>
              <p:nvPr/>
            </p:nvGrpSpPr>
            <p:grpSpPr>
              <a:xfrm>
                <a:off x="3377639" y="7990202"/>
                <a:ext cx="2980185" cy="2498651"/>
                <a:chOff x="3377639" y="7995197"/>
                <a:chExt cx="2980185" cy="2498651"/>
              </a:xfrm>
            </p:grpSpPr>
            <p:grpSp>
              <p:nvGrpSpPr>
                <p:cNvPr id="245" name="그룹 182"/>
                <p:cNvGrpSpPr/>
                <p:nvPr/>
              </p:nvGrpSpPr>
              <p:grpSpPr>
                <a:xfrm>
                  <a:off x="3377639" y="7995197"/>
                  <a:ext cx="2980185" cy="2498651"/>
                  <a:chOff x="3377639" y="7995197"/>
                  <a:chExt cx="2980185" cy="2498651"/>
                </a:xfrm>
              </p:grpSpPr>
              <p:grpSp>
                <p:nvGrpSpPr>
                  <p:cNvPr id="247" name="그룹 184"/>
                  <p:cNvGrpSpPr/>
                  <p:nvPr/>
                </p:nvGrpSpPr>
                <p:grpSpPr>
                  <a:xfrm>
                    <a:off x="3377639" y="7995197"/>
                    <a:ext cx="2980185" cy="2498651"/>
                    <a:chOff x="3373043" y="8015088"/>
                    <a:chExt cx="2980185" cy="2498651"/>
                  </a:xfrm>
                </p:grpSpPr>
                <p:pic>
                  <p:nvPicPr>
                    <p:cNvPr id="249" name="그림 186"/>
                    <p:cNvPicPr>
                      <a:picLocks noChangeAspect="1"/>
                    </p:cNvPicPr>
                    <p:nvPr/>
                  </p:nvPicPr>
                  <p:blipFill rotWithShape="1"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16" b="15593"/>
                    <a:stretch/>
                  </p:blipFill>
                  <p:spPr>
                    <a:xfrm>
                      <a:off x="3373043" y="8015088"/>
                      <a:ext cx="2980185" cy="2498651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50" name="TextBox 249"/>
                    <p:cNvSpPr txBox="1"/>
                    <p:nvPr/>
                  </p:nvSpPr>
                  <p:spPr>
                    <a:xfrm>
                      <a:off x="5463296" y="8125847"/>
                      <a:ext cx="564453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ko-KR" altLang="en-US" sz="1200" dirty="0"/>
                    </a:p>
                  </p:txBody>
                </p:sp>
              </p:grpSp>
              <p:sp>
                <p:nvSpPr>
                  <p:cNvPr id="248" name="TextBox 247">
                    <a:extLst>
                      <a:ext uri="{FF2B5EF4-FFF2-40B4-BE49-F238E27FC236}">
                        <a16:creationId xmlns:a16="http://schemas.microsoft.com/office/drawing/2014/main" id="{9B50F5FC-210D-467F-9397-6EF4EE71BC78}"/>
                      </a:ext>
                    </a:extLst>
                  </p:cNvPr>
                  <p:cNvSpPr txBox="1"/>
                  <p:nvPr/>
                </p:nvSpPr>
                <p:spPr>
                  <a:xfrm>
                    <a:off x="4619913" y="8582763"/>
                    <a:ext cx="1515713" cy="55399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Gross </a:t>
                    </a:r>
                    <a:r>
                      <a:rPr lang="en-US" sz="1000" dirty="0" smtClean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type Infiltrative&gt;sessile&gt;</a:t>
                    </a:r>
                    <a:r>
                      <a:rPr lang="en-US" sz="1000" dirty="0" err="1" smtClean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fungating</a:t>
                    </a:r>
                    <a:r>
                      <a:rPr lang="en-US" sz="1000" dirty="0" smtClean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&gt;solid</a:t>
                    </a:r>
                    <a:endParaRPr lang="en-US" sz="1000" dirty="0">
                      <a:latin typeface="Arial Black" panose="020B0A040201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46" name="TextBox 245"/>
                <p:cNvSpPr txBox="1"/>
                <p:nvPr/>
              </p:nvSpPr>
              <p:spPr>
                <a:xfrm>
                  <a:off x="5434538" y="8044674"/>
                  <a:ext cx="82254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823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238" name="그룹 175"/>
              <p:cNvGrpSpPr/>
              <p:nvPr/>
            </p:nvGrpSpPr>
            <p:grpSpPr>
              <a:xfrm>
                <a:off x="6647405" y="10807099"/>
                <a:ext cx="2980185" cy="2502417"/>
                <a:chOff x="6647405" y="10812094"/>
                <a:chExt cx="2980185" cy="2502417"/>
              </a:xfrm>
            </p:grpSpPr>
            <p:grpSp>
              <p:nvGrpSpPr>
                <p:cNvPr id="239" name="그룹 176"/>
                <p:cNvGrpSpPr/>
                <p:nvPr/>
              </p:nvGrpSpPr>
              <p:grpSpPr>
                <a:xfrm>
                  <a:off x="6647405" y="10812094"/>
                  <a:ext cx="2980185" cy="2502417"/>
                  <a:chOff x="6654271" y="10830849"/>
                  <a:chExt cx="2980185" cy="2502417"/>
                </a:xfrm>
              </p:grpSpPr>
              <p:grpSp>
                <p:nvGrpSpPr>
                  <p:cNvPr id="241" name="그룹 178"/>
                  <p:cNvGrpSpPr/>
                  <p:nvPr/>
                </p:nvGrpSpPr>
                <p:grpSpPr>
                  <a:xfrm>
                    <a:off x="6654271" y="10830849"/>
                    <a:ext cx="2980185" cy="2502417"/>
                    <a:chOff x="5309348" y="11709536"/>
                    <a:chExt cx="4043260" cy="2330174"/>
                  </a:xfrm>
                </p:grpSpPr>
                <p:pic>
                  <p:nvPicPr>
                    <p:cNvPr id="243" name="그림 180"/>
                    <p:cNvPicPr>
                      <a:picLocks noChangeAspect="1"/>
                    </p:cNvPicPr>
                    <p:nvPr/>
                  </p:nvPicPr>
                  <p:blipFill rotWithShape="1"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5564"/>
                    <a:stretch/>
                  </p:blipFill>
                  <p:spPr>
                    <a:xfrm>
                      <a:off x="5309348" y="11709536"/>
                      <a:ext cx="4043260" cy="2330174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44" name="TextBox 243">
                      <a:extLst>
                        <a:ext uri="{FF2B5EF4-FFF2-40B4-BE49-F238E27FC236}">
                          <a16:creationId xmlns:a16="http://schemas.microsoft.com/office/drawing/2014/main" id="{CE19126B-4A78-42B1-93DF-60738C11D5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26436" y="12356321"/>
                      <a:ext cx="1181347" cy="25793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latin typeface="Arial Black" panose="020B0A04020102020204" pitchFamily="34" charset="0"/>
                        </a:rPr>
                        <a:t>M stage </a:t>
                      </a:r>
                    </a:p>
                  </p:txBody>
                </p:sp>
              </p:grpSp>
              <p:sp>
                <p:nvSpPr>
                  <p:cNvPr id="242" name="TextBox 241"/>
                  <p:cNvSpPr txBox="1"/>
                  <p:nvPr/>
                </p:nvSpPr>
                <p:spPr>
                  <a:xfrm>
                    <a:off x="8773138" y="11000962"/>
                    <a:ext cx="564453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40" name="TextBox 239"/>
                <p:cNvSpPr txBox="1"/>
                <p:nvPr/>
              </p:nvSpPr>
              <p:spPr>
                <a:xfrm>
                  <a:off x="8796513" y="10871428"/>
                  <a:ext cx="734836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189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</p:grp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95230834-C4B6-45C5-A88B-C8A49CA6C558}"/>
                </a:ext>
              </a:extLst>
            </p:cNvPr>
            <p:cNvSpPr txBox="1"/>
            <p:nvPr/>
          </p:nvSpPr>
          <p:spPr>
            <a:xfrm>
              <a:off x="6166029" y="3913813"/>
              <a:ext cx="6641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ge&lt;74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95230834-C4B6-45C5-A88B-C8A49CA6C558}"/>
                </a:ext>
              </a:extLst>
            </p:cNvPr>
            <p:cNvSpPr txBox="1"/>
            <p:nvPr/>
          </p:nvSpPr>
          <p:spPr>
            <a:xfrm>
              <a:off x="5577874" y="4369890"/>
              <a:ext cx="66274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 Black" panose="020B0A04020102020204" pitchFamily="34" charset="0"/>
                  <a:cs typeface="Times New Roman" panose="02020603050405020304" pitchFamily="18" charset="0"/>
                </a:rPr>
                <a:t>Age&gt;74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A64BE34-63FF-426E-BD17-B6C0EEA88095}"/>
                </a:ext>
              </a:extLst>
            </p:cNvPr>
            <p:cNvSpPr txBox="1"/>
            <p:nvPr/>
          </p:nvSpPr>
          <p:spPr>
            <a:xfrm>
              <a:off x="9649925" y="4308456"/>
              <a:ext cx="50001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Male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9A64BE34-63FF-426E-BD17-B6C0EEA88095}"/>
                </a:ext>
              </a:extLst>
            </p:cNvPr>
            <p:cNvSpPr txBox="1"/>
            <p:nvPr/>
          </p:nvSpPr>
          <p:spPr>
            <a:xfrm>
              <a:off x="9479572" y="3880920"/>
              <a:ext cx="67154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Female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6169223" y="6412665"/>
              <a:ext cx="4903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OV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6330571" y="7092122"/>
              <a:ext cx="46454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CBD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5239647" y="7112013"/>
              <a:ext cx="86434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ancreas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8624793" y="5236452"/>
              <a:ext cx="37204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T0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9761559" y="6624642"/>
              <a:ext cx="34461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T1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9759393" y="7042511"/>
              <a:ext cx="34516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T2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9501527" y="7202766"/>
              <a:ext cx="34425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T3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9531176" y="9216304"/>
              <a:ext cx="72778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ize&lt;1.5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9400414" y="10006502"/>
              <a:ext cx="74673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ize&gt;1.5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5107411" y="8130072"/>
              <a:ext cx="84191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Infiltrative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5986794" y="9252264"/>
              <a:ext cx="64313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essile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5062141" y="8485278"/>
              <a:ext cx="80648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err="1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Fungative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998206EC-C4E0-4D41-AE5D-1990D47CCAE3}"/>
                </a:ext>
              </a:extLst>
            </p:cNvPr>
            <p:cNvSpPr txBox="1"/>
            <p:nvPr/>
          </p:nvSpPr>
          <p:spPr>
            <a:xfrm>
              <a:off x="6303844" y="10016279"/>
              <a:ext cx="51087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olid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A9E65EF3-E210-4BD2-AE8A-C47DE43BE763}"/>
                </a:ext>
              </a:extLst>
            </p:cNvPr>
            <p:cNvSpPr txBox="1"/>
            <p:nvPr/>
          </p:nvSpPr>
          <p:spPr>
            <a:xfrm>
              <a:off x="9747047" y="12851332"/>
              <a:ext cx="39472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Arial" panose="020B0604020202020204" pitchFamily="34" charset="0"/>
                </a:rPr>
                <a:t>M0</a:t>
              </a:r>
              <a:endParaRPr lang="en-US" sz="900" b="1" dirty="0"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A9E65EF3-E210-4BD2-AE8A-C47DE43BE763}"/>
                </a:ext>
              </a:extLst>
            </p:cNvPr>
            <p:cNvSpPr txBox="1"/>
            <p:nvPr/>
          </p:nvSpPr>
          <p:spPr>
            <a:xfrm>
              <a:off x="8271607" y="11237300"/>
              <a:ext cx="41075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Arial" panose="020B0604020202020204" pitchFamily="34" charset="0"/>
                </a:rPr>
                <a:t>M1</a:t>
              </a:r>
              <a:endParaRPr lang="en-US" sz="900" b="1" dirty="0"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5ECE7EF1-6908-41EC-8CC3-471B6DC4B246}"/>
                </a:ext>
              </a:extLst>
            </p:cNvPr>
            <p:cNvSpPr txBox="1"/>
            <p:nvPr/>
          </p:nvSpPr>
          <p:spPr>
            <a:xfrm>
              <a:off x="6424376" y="12406254"/>
              <a:ext cx="36462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N0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5ECE7EF1-6908-41EC-8CC3-471B6DC4B246}"/>
                </a:ext>
              </a:extLst>
            </p:cNvPr>
            <p:cNvSpPr txBox="1"/>
            <p:nvPr/>
          </p:nvSpPr>
          <p:spPr>
            <a:xfrm>
              <a:off x="6423907" y="12878129"/>
              <a:ext cx="38317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N1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20762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>
            <a:extLst>
              <a:ext uri="{FF2B5EF4-FFF2-40B4-BE49-F238E27FC236}">
                <a16:creationId xmlns:a16="http://schemas.microsoft.com/office/drawing/2014/main" id="{7A1FE1BF-5739-49B6-A03B-AF7537DE2A5D}"/>
              </a:ext>
            </a:extLst>
          </p:cNvPr>
          <p:cNvSpPr txBox="1"/>
          <p:nvPr/>
        </p:nvSpPr>
        <p:spPr>
          <a:xfrm>
            <a:off x="2868748" y="13960976"/>
            <a:ext cx="85017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analysis on the relationship between  disease fre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and pathological parameter in recurrent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iampullary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pancreatic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s . There was significant difference according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lymphatic invasion, (E) histological differentiation, (F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creatobillar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vs intestinal type, and (G) fibrosis, while there was no significant relationship according to (B) vascular Invasion, (C) perineural invasion, (D) radial margin involvement, and (H) inflammation.</a:t>
            </a:r>
          </a:p>
        </p:txBody>
      </p:sp>
      <p:grpSp>
        <p:nvGrpSpPr>
          <p:cNvPr id="114" name="Group 113"/>
          <p:cNvGrpSpPr/>
          <p:nvPr/>
        </p:nvGrpSpPr>
        <p:grpSpPr>
          <a:xfrm>
            <a:off x="2970362" y="384774"/>
            <a:ext cx="8064896" cy="13521600"/>
            <a:chOff x="3565154" y="2664867"/>
            <a:chExt cx="6606008" cy="11075629"/>
          </a:xfrm>
        </p:grpSpPr>
        <p:grpSp>
          <p:nvGrpSpPr>
            <p:cNvPr id="119" name="그룹 231"/>
            <p:cNvGrpSpPr/>
            <p:nvPr/>
          </p:nvGrpSpPr>
          <p:grpSpPr>
            <a:xfrm>
              <a:off x="3565154" y="2664867"/>
              <a:ext cx="6606008" cy="11075629"/>
              <a:chOff x="3052131" y="2224986"/>
              <a:chExt cx="6606008" cy="11075629"/>
            </a:xfrm>
          </p:grpSpPr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10ED5E60-BEBB-4AD2-B113-7B834F4DB424}"/>
                  </a:ext>
                </a:extLst>
              </p:cNvPr>
              <p:cNvSpPr txBox="1"/>
              <p:nvPr/>
            </p:nvSpPr>
            <p:spPr>
              <a:xfrm>
                <a:off x="3052131" y="2237048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A.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0A4146DC-4497-4450-B452-49B8FA9BA704}"/>
                  </a:ext>
                </a:extLst>
              </p:cNvPr>
              <p:cNvSpPr txBox="1"/>
              <p:nvPr/>
            </p:nvSpPr>
            <p:spPr>
              <a:xfrm>
                <a:off x="6397057" y="2224986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B.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15C90AE8-1BF2-4399-A383-F4F9BA99CB63}"/>
                  </a:ext>
                </a:extLst>
              </p:cNvPr>
              <p:cNvSpPr txBox="1"/>
              <p:nvPr/>
            </p:nvSpPr>
            <p:spPr>
              <a:xfrm>
                <a:off x="3071998" y="5037109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C.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8421C2DF-CFC3-4846-AECE-1BE7B1996054}"/>
                  </a:ext>
                </a:extLst>
              </p:cNvPr>
              <p:cNvSpPr txBox="1"/>
              <p:nvPr/>
            </p:nvSpPr>
            <p:spPr>
              <a:xfrm>
                <a:off x="6426746" y="5041887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D.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39FFDA67-38E6-42AE-87F4-F5F3965D5D7F}"/>
                  </a:ext>
                </a:extLst>
              </p:cNvPr>
              <p:cNvSpPr txBox="1"/>
              <p:nvPr/>
            </p:nvSpPr>
            <p:spPr>
              <a:xfrm>
                <a:off x="3081415" y="7921451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E.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6B67F517-86E4-4BD6-B6EE-D357CC46F37B}"/>
                  </a:ext>
                </a:extLst>
              </p:cNvPr>
              <p:cNvSpPr txBox="1"/>
              <p:nvPr/>
            </p:nvSpPr>
            <p:spPr>
              <a:xfrm>
                <a:off x="6436689" y="7931784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F.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AAC337B8-92AA-4A5E-9D11-26ED14576443}"/>
                  </a:ext>
                </a:extLst>
              </p:cNvPr>
              <p:cNvSpPr txBox="1"/>
              <p:nvPr/>
            </p:nvSpPr>
            <p:spPr>
              <a:xfrm>
                <a:off x="3081415" y="10729421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G.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9EF7EE1A-D830-405A-B220-FDC47D670C2C}"/>
                  </a:ext>
                </a:extLst>
              </p:cNvPr>
              <p:cNvSpPr txBox="1"/>
              <p:nvPr/>
            </p:nvSpPr>
            <p:spPr>
              <a:xfrm>
                <a:off x="6405066" y="10734485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H.</a:t>
                </a: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8761981" y="2463722"/>
                <a:ext cx="412185" cy="1871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ko-KR" altLang="en-US" dirty="0"/>
              </a:p>
            </p:txBody>
          </p:sp>
          <p:grpSp>
            <p:nvGrpSpPr>
              <p:cNvPr id="151" name="그룹 241"/>
              <p:cNvGrpSpPr/>
              <p:nvPr/>
            </p:nvGrpSpPr>
            <p:grpSpPr>
              <a:xfrm>
                <a:off x="3375524" y="2312011"/>
                <a:ext cx="2980185" cy="2492239"/>
                <a:chOff x="2970972" y="828739"/>
                <a:chExt cx="2980185" cy="2492239"/>
              </a:xfrm>
            </p:grpSpPr>
            <p:grpSp>
              <p:nvGrpSpPr>
                <p:cNvPr id="201" name="그룹 291"/>
                <p:cNvGrpSpPr/>
                <p:nvPr/>
              </p:nvGrpSpPr>
              <p:grpSpPr>
                <a:xfrm>
                  <a:off x="2970972" y="828739"/>
                  <a:ext cx="2980185" cy="2492239"/>
                  <a:chOff x="2970972" y="828739"/>
                  <a:chExt cx="2980185" cy="2492239"/>
                </a:xfrm>
              </p:grpSpPr>
              <p:grpSp>
                <p:nvGrpSpPr>
                  <p:cNvPr id="203" name="그룹 293"/>
                  <p:cNvGrpSpPr/>
                  <p:nvPr/>
                </p:nvGrpSpPr>
                <p:grpSpPr>
                  <a:xfrm>
                    <a:off x="2970972" y="828739"/>
                    <a:ext cx="2980185" cy="2492239"/>
                    <a:chOff x="7506866" y="646606"/>
                    <a:chExt cx="2980185" cy="2492239"/>
                  </a:xfrm>
                </p:grpSpPr>
                <p:pic>
                  <p:nvPicPr>
                    <p:cNvPr id="205" name="그림 295"/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9538"/>
                    <a:stretch/>
                  </p:blipFill>
                  <p:spPr>
                    <a:xfrm>
                      <a:off x="7506866" y="646606"/>
                      <a:ext cx="2980185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06" name="TextBox 205">
                      <a:extLst>
                        <a:ext uri="{FF2B5EF4-FFF2-40B4-BE49-F238E27FC236}">
                          <a16:creationId xmlns:a16="http://schemas.microsoft.com/office/drawing/2014/main" id="{B8E093EF-12FE-4816-8B5D-702F8962A4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90310" y="1341348"/>
                      <a:ext cx="1596122" cy="24622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Lymphatic Invasion</a:t>
                      </a:r>
                    </a:p>
                  </p:txBody>
                </p:sp>
              </p:grpSp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4981651" y="930897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202" name="TextBox 201"/>
                <p:cNvSpPr txBox="1"/>
                <p:nvPr/>
              </p:nvSpPr>
              <p:spPr>
                <a:xfrm>
                  <a:off x="5045772" y="884744"/>
                  <a:ext cx="82569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&lt;0.0001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2" name="그룹 242"/>
              <p:cNvGrpSpPr/>
              <p:nvPr/>
            </p:nvGrpSpPr>
            <p:grpSpPr>
              <a:xfrm>
                <a:off x="3372615" y="5126662"/>
                <a:ext cx="2980185" cy="2478909"/>
                <a:chOff x="2970971" y="3528963"/>
                <a:chExt cx="2980185" cy="2478909"/>
              </a:xfrm>
            </p:grpSpPr>
            <p:grpSp>
              <p:nvGrpSpPr>
                <p:cNvPr id="195" name="그룹 285"/>
                <p:cNvGrpSpPr/>
                <p:nvPr/>
              </p:nvGrpSpPr>
              <p:grpSpPr>
                <a:xfrm>
                  <a:off x="2970971" y="3528963"/>
                  <a:ext cx="2980185" cy="2478909"/>
                  <a:chOff x="2970971" y="3528963"/>
                  <a:chExt cx="2980185" cy="2478909"/>
                </a:xfrm>
              </p:grpSpPr>
              <p:grpSp>
                <p:nvGrpSpPr>
                  <p:cNvPr id="197" name="그룹 287"/>
                  <p:cNvGrpSpPr/>
                  <p:nvPr/>
                </p:nvGrpSpPr>
                <p:grpSpPr>
                  <a:xfrm>
                    <a:off x="2970971" y="3528963"/>
                    <a:ext cx="2980185" cy="2478909"/>
                    <a:chOff x="540381" y="5874590"/>
                    <a:chExt cx="2980185" cy="2478909"/>
                  </a:xfrm>
                </p:grpSpPr>
                <p:pic>
                  <p:nvPicPr>
                    <p:cNvPr id="199" name="그림 289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5564"/>
                    <a:stretch/>
                  </p:blipFill>
                  <p:spPr>
                    <a:xfrm>
                      <a:off x="540381" y="5874590"/>
                      <a:ext cx="2980185" cy="247890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200" name="TextBox 199">
                      <a:extLst>
                        <a:ext uri="{FF2B5EF4-FFF2-40B4-BE49-F238E27FC236}">
                          <a16:creationId xmlns:a16="http://schemas.microsoft.com/office/drawing/2014/main" id="{BB5D9038-49D6-4BDD-BA6C-6FEE27EF99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4192" y="6545803"/>
                      <a:ext cx="1545605" cy="24622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Perineural Invasion</a:t>
                      </a:r>
                    </a:p>
                  </p:txBody>
                </p:sp>
              </p:grpSp>
              <p:sp>
                <p:nvSpPr>
                  <p:cNvPr id="198" name="TextBox 197"/>
                  <p:cNvSpPr txBox="1"/>
                  <p:nvPr/>
                </p:nvSpPr>
                <p:spPr>
                  <a:xfrm>
                    <a:off x="5028152" y="3653772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96" name="TextBox 195"/>
                <p:cNvSpPr txBox="1"/>
                <p:nvPr/>
              </p:nvSpPr>
              <p:spPr>
                <a:xfrm>
                  <a:off x="5114365" y="3582446"/>
                  <a:ext cx="737090" cy="244604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155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3" name="그룹 243"/>
              <p:cNvGrpSpPr/>
              <p:nvPr/>
            </p:nvGrpSpPr>
            <p:grpSpPr>
              <a:xfrm>
                <a:off x="6649451" y="5121897"/>
                <a:ext cx="3008688" cy="2486404"/>
                <a:chOff x="6132801" y="3524935"/>
                <a:chExt cx="3008688" cy="2486404"/>
              </a:xfrm>
            </p:grpSpPr>
            <p:grpSp>
              <p:nvGrpSpPr>
                <p:cNvPr id="189" name="그룹 279"/>
                <p:cNvGrpSpPr/>
                <p:nvPr/>
              </p:nvGrpSpPr>
              <p:grpSpPr>
                <a:xfrm>
                  <a:off x="6132801" y="3524935"/>
                  <a:ext cx="3008688" cy="2486404"/>
                  <a:chOff x="6132801" y="3524935"/>
                  <a:chExt cx="3008688" cy="2486404"/>
                </a:xfrm>
              </p:grpSpPr>
              <p:grpSp>
                <p:nvGrpSpPr>
                  <p:cNvPr id="191" name="그룹 281"/>
                  <p:cNvGrpSpPr/>
                  <p:nvPr/>
                </p:nvGrpSpPr>
                <p:grpSpPr>
                  <a:xfrm>
                    <a:off x="6132801" y="3524935"/>
                    <a:ext cx="3008688" cy="2486404"/>
                    <a:chOff x="4356649" y="9626565"/>
                    <a:chExt cx="3714807" cy="2486404"/>
                  </a:xfrm>
                </p:grpSpPr>
                <p:pic>
                  <p:nvPicPr>
                    <p:cNvPr id="193" name="그림 283"/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10" t="3671" r="-610" b="15246"/>
                    <a:stretch/>
                  </p:blipFill>
                  <p:spPr>
                    <a:xfrm>
                      <a:off x="4356649" y="9626565"/>
                      <a:ext cx="3714807" cy="2486404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94" name="TextBox 193">
                      <a:extLst>
                        <a:ext uri="{FF2B5EF4-FFF2-40B4-BE49-F238E27FC236}">
                          <a16:creationId xmlns:a16="http://schemas.microsoft.com/office/drawing/2014/main" id="{2A6AC043-0B8D-400F-8980-081F81E35D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91374" y="10300412"/>
                      <a:ext cx="2518846" cy="24622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Radial margin </a:t>
                      </a:r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involvement</a:t>
                      </a:r>
                    </a:p>
                  </p:txBody>
                </p:sp>
              </p:grpSp>
              <p:sp>
                <p:nvSpPr>
                  <p:cNvPr id="192" name="TextBox 191"/>
                  <p:cNvSpPr txBox="1"/>
                  <p:nvPr/>
                </p:nvSpPr>
                <p:spPr>
                  <a:xfrm>
                    <a:off x="8147075" y="3714074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90" name="TextBox 189"/>
                <p:cNvSpPr txBox="1"/>
                <p:nvPr/>
              </p:nvSpPr>
              <p:spPr>
                <a:xfrm>
                  <a:off x="8277284" y="3581059"/>
                  <a:ext cx="737090" cy="244604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273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4" name="그룹 244"/>
              <p:cNvGrpSpPr/>
              <p:nvPr/>
            </p:nvGrpSpPr>
            <p:grpSpPr>
              <a:xfrm>
                <a:off x="3375927" y="7998087"/>
                <a:ext cx="2987753" cy="2492239"/>
                <a:chOff x="2974754" y="6402490"/>
                <a:chExt cx="2987753" cy="2492239"/>
              </a:xfrm>
            </p:grpSpPr>
            <p:grpSp>
              <p:nvGrpSpPr>
                <p:cNvPr id="183" name="그룹 273"/>
                <p:cNvGrpSpPr/>
                <p:nvPr/>
              </p:nvGrpSpPr>
              <p:grpSpPr>
                <a:xfrm>
                  <a:off x="2974754" y="6402490"/>
                  <a:ext cx="2987753" cy="2492239"/>
                  <a:chOff x="2974754" y="6402490"/>
                  <a:chExt cx="2987753" cy="2492239"/>
                </a:xfrm>
              </p:grpSpPr>
              <p:grpSp>
                <p:nvGrpSpPr>
                  <p:cNvPr id="185" name="그룹 275"/>
                  <p:cNvGrpSpPr/>
                  <p:nvPr/>
                </p:nvGrpSpPr>
                <p:grpSpPr>
                  <a:xfrm>
                    <a:off x="2974754" y="6402490"/>
                    <a:ext cx="2987753" cy="2492239"/>
                    <a:chOff x="540381" y="6913339"/>
                    <a:chExt cx="2987753" cy="2492239"/>
                  </a:xfrm>
                </p:grpSpPr>
                <p:pic>
                  <p:nvPicPr>
                    <p:cNvPr id="187" name="그림 277"/>
                    <p:cNvPicPr>
                      <a:picLocks noChangeAspect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4240"/>
                    <a:stretch/>
                  </p:blipFill>
                  <p:spPr>
                    <a:xfrm>
                      <a:off x="540381" y="6913339"/>
                      <a:ext cx="2987753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88" name="TextBox 187">
                      <a:extLst>
                        <a:ext uri="{FF2B5EF4-FFF2-40B4-BE49-F238E27FC236}">
                          <a16:creationId xmlns:a16="http://schemas.microsoft.com/office/drawing/2014/main" id="{65D96F99-C615-4C27-8F6F-DE8637B5F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81682" y="7595073"/>
                      <a:ext cx="2058788" cy="24622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 smtClean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Histological differentiation</a:t>
                      </a:r>
                      <a:endParaRPr lang="en-US" sz="1000" dirty="0">
                        <a:latin typeface="Arial Black" panose="020B0A0402010202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5001214" y="6451082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84" name="TextBox 183"/>
                <p:cNvSpPr txBox="1"/>
                <p:nvPr/>
              </p:nvSpPr>
              <p:spPr>
                <a:xfrm>
                  <a:off x="4929213" y="6450906"/>
                  <a:ext cx="935550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0121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5" name="그룹 245"/>
              <p:cNvGrpSpPr/>
              <p:nvPr/>
            </p:nvGrpSpPr>
            <p:grpSpPr>
              <a:xfrm>
                <a:off x="6654454" y="7998086"/>
                <a:ext cx="2980185" cy="2492239"/>
                <a:chOff x="6135344" y="6404229"/>
                <a:chExt cx="2980185" cy="2492239"/>
              </a:xfrm>
            </p:grpSpPr>
            <p:grpSp>
              <p:nvGrpSpPr>
                <p:cNvPr id="177" name="그룹 267"/>
                <p:cNvGrpSpPr/>
                <p:nvPr/>
              </p:nvGrpSpPr>
              <p:grpSpPr>
                <a:xfrm>
                  <a:off x="6135344" y="6404229"/>
                  <a:ext cx="2980185" cy="2492239"/>
                  <a:chOff x="6135344" y="6404229"/>
                  <a:chExt cx="2980185" cy="2492239"/>
                </a:xfrm>
              </p:grpSpPr>
              <p:grpSp>
                <p:nvGrpSpPr>
                  <p:cNvPr id="179" name="그룹 269"/>
                  <p:cNvGrpSpPr/>
                  <p:nvPr/>
                </p:nvGrpSpPr>
                <p:grpSpPr>
                  <a:xfrm>
                    <a:off x="6135344" y="6404229"/>
                    <a:ext cx="2980185" cy="2492239"/>
                    <a:chOff x="547949" y="3138977"/>
                    <a:chExt cx="2980185" cy="2492239"/>
                  </a:xfrm>
                </p:grpSpPr>
                <p:pic>
                  <p:nvPicPr>
                    <p:cNvPr id="181" name="그림 271"/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5564"/>
                    <a:stretch/>
                  </p:blipFill>
                  <p:spPr>
                    <a:xfrm>
                      <a:off x="547949" y="3138977"/>
                      <a:ext cx="2980185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82" name="TextBox 181">
                      <a:extLst>
                        <a:ext uri="{FF2B5EF4-FFF2-40B4-BE49-F238E27FC236}">
                          <a16:creationId xmlns:a16="http://schemas.microsoft.com/office/drawing/2014/main" id="{B3B876D4-1FB3-4362-A25E-62C15E75CF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6499" y="3672794"/>
                      <a:ext cx="1754616" cy="40011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Pancreatobillary</a:t>
                      </a:r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 smtClean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type/ Intestinal </a:t>
                      </a:r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type</a:t>
                      </a:r>
                    </a:p>
                  </p:txBody>
                </p:sp>
              </p:grp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8202098" y="6486111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78" name="TextBox 177"/>
                <p:cNvSpPr txBox="1"/>
                <p:nvPr/>
              </p:nvSpPr>
              <p:spPr>
                <a:xfrm>
                  <a:off x="8152341" y="6467212"/>
                  <a:ext cx="843932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417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6" name="그룹 246"/>
              <p:cNvGrpSpPr/>
              <p:nvPr/>
            </p:nvGrpSpPr>
            <p:grpSpPr>
              <a:xfrm>
                <a:off x="3359680" y="10808376"/>
                <a:ext cx="2980794" cy="2492239"/>
                <a:chOff x="2970362" y="9177723"/>
                <a:chExt cx="2980794" cy="2492239"/>
              </a:xfrm>
            </p:grpSpPr>
            <p:grpSp>
              <p:nvGrpSpPr>
                <p:cNvPr id="171" name="그룹 261"/>
                <p:cNvGrpSpPr/>
                <p:nvPr/>
              </p:nvGrpSpPr>
              <p:grpSpPr>
                <a:xfrm>
                  <a:off x="2970362" y="9177723"/>
                  <a:ext cx="2980794" cy="2492239"/>
                  <a:chOff x="2970362" y="9177723"/>
                  <a:chExt cx="2980794" cy="2492239"/>
                </a:xfrm>
              </p:grpSpPr>
              <p:grpSp>
                <p:nvGrpSpPr>
                  <p:cNvPr id="173" name="그룹 263"/>
                  <p:cNvGrpSpPr/>
                  <p:nvPr/>
                </p:nvGrpSpPr>
                <p:grpSpPr>
                  <a:xfrm>
                    <a:off x="2970362" y="9177723"/>
                    <a:ext cx="2980794" cy="2492239"/>
                    <a:chOff x="2256726" y="2736875"/>
                    <a:chExt cx="2980794" cy="2492239"/>
                  </a:xfrm>
                </p:grpSpPr>
                <p:pic>
                  <p:nvPicPr>
                    <p:cNvPr id="175" name="그림 265"/>
                    <p:cNvPicPr>
                      <a:picLocks noChangeAspect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574" b="15634"/>
                    <a:stretch/>
                  </p:blipFill>
                  <p:spPr>
                    <a:xfrm>
                      <a:off x="2256726" y="2736875"/>
                      <a:ext cx="2980794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76" name="TextBox 175">
                      <a:extLst>
                        <a:ext uri="{FF2B5EF4-FFF2-40B4-BE49-F238E27FC236}">
                          <a16:creationId xmlns:a16="http://schemas.microsoft.com/office/drawing/2014/main" id="{8D3B94F6-DA00-412A-BA69-4B86B1DBB6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54475" y="3407811"/>
                      <a:ext cx="818820" cy="26161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Fibrosis</a:t>
                      </a:r>
                    </a:p>
                  </p:txBody>
                </p:sp>
              </p:grpSp>
              <p:sp>
                <p:nvSpPr>
                  <p:cNvPr id="174" name="TextBox 173"/>
                  <p:cNvSpPr txBox="1"/>
                  <p:nvPr/>
                </p:nvSpPr>
                <p:spPr>
                  <a:xfrm>
                    <a:off x="5001214" y="9310266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72" name="TextBox 171"/>
                <p:cNvSpPr txBox="1"/>
                <p:nvPr/>
              </p:nvSpPr>
              <p:spPr>
                <a:xfrm>
                  <a:off x="5044235" y="9239976"/>
                  <a:ext cx="817024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259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7" name="그룹 247"/>
              <p:cNvGrpSpPr/>
              <p:nvPr/>
            </p:nvGrpSpPr>
            <p:grpSpPr>
              <a:xfrm>
                <a:off x="6644763" y="2312011"/>
                <a:ext cx="2994648" cy="2486404"/>
                <a:chOff x="6135344" y="807408"/>
                <a:chExt cx="2994648" cy="2480441"/>
              </a:xfrm>
            </p:grpSpPr>
            <p:grpSp>
              <p:nvGrpSpPr>
                <p:cNvPr id="165" name="그룹 255"/>
                <p:cNvGrpSpPr/>
                <p:nvPr/>
              </p:nvGrpSpPr>
              <p:grpSpPr>
                <a:xfrm>
                  <a:off x="6135344" y="807408"/>
                  <a:ext cx="2994648" cy="2480441"/>
                  <a:chOff x="6135344" y="807408"/>
                  <a:chExt cx="2994648" cy="2480441"/>
                </a:xfrm>
              </p:grpSpPr>
              <p:grpSp>
                <p:nvGrpSpPr>
                  <p:cNvPr id="167" name="그룹 257"/>
                  <p:cNvGrpSpPr/>
                  <p:nvPr/>
                </p:nvGrpSpPr>
                <p:grpSpPr>
                  <a:xfrm>
                    <a:off x="6135344" y="807408"/>
                    <a:ext cx="2994648" cy="2480441"/>
                    <a:chOff x="7123298" y="4318909"/>
                    <a:chExt cx="2994648" cy="2480441"/>
                  </a:xfrm>
                  <a:solidFill>
                    <a:schemeClr val="bg1"/>
                  </a:solidFill>
                </p:grpSpPr>
                <p:pic>
                  <p:nvPicPr>
                    <p:cNvPr id="169" name="그림 259"/>
                    <p:cNvPicPr>
                      <a:picLocks noChangeAspect="1"/>
                    </p:cNvPicPr>
                    <p:nvPr/>
                  </p:nvPicPr>
                  <p:blipFill rotWithShape="1"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973" b="15236"/>
                    <a:stretch/>
                  </p:blipFill>
                  <p:spPr>
                    <a:xfrm>
                      <a:off x="7123298" y="4318909"/>
                      <a:ext cx="2994648" cy="2480441"/>
                    </a:xfrm>
                    <a:prstGeom prst="rect">
                      <a:avLst/>
                    </a:prstGeom>
                    <a:grpFill/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70" name="TextBox 169">
                      <a:extLst>
                        <a:ext uri="{FF2B5EF4-FFF2-40B4-BE49-F238E27FC236}">
                          <a16:creationId xmlns:a16="http://schemas.microsoft.com/office/drawing/2014/main" id="{DB43D9E2-3551-44FD-BA61-246FC0D4C7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62367" y="5004923"/>
                      <a:ext cx="1432923" cy="245631"/>
                    </a:xfrm>
                    <a:prstGeom prst="rect">
                      <a:avLst/>
                    </a:prstGeom>
                    <a:grpFill/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Vascular Invasion</a:t>
                      </a:r>
                    </a:p>
                  </p:txBody>
                </p:sp>
              </p:grpSp>
              <p:sp>
                <p:nvSpPr>
                  <p:cNvPr id="168" name="TextBox 167"/>
                  <p:cNvSpPr txBox="1"/>
                  <p:nvPr/>
                </p:nvSpPr>
                <p:spPr>
                  <a:xfrm>
                    <a:off x="8215206" y="901101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66" name="TextBox 165"/>
                <p:cNvSpPr txBox="1"/>
                <p:nvPr/>
              </p:nvSpPr>
              <p:spPr>
                <a:xfrm>
                  <a:off x="8206166" y="853571"/>
                  <a:ext cx="823643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0714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58" name="그룹 248"/>
              <p:cNvGrpSpPr/>
              <p:nvPr/>
            </p:nvGrpSpPr>
            <p:grpSpPr>
              <a:xfrm>
                <a:off x="6649452" y="10808376"/>
                <a:ext cx="2980185" cy="2492239"/>
                <a:chOff x="6107685" y="9182992"/>
                <a:chExt cx="2980185" cy="2492239"/>
              </a:xfrm>
            </p:grpSpPr>
            <p:grpSp>
              <p:nvGrpSpPr>
                <p:cNvPr id="159" name="그룹 249"/>
                <p:cNvGrpSpPr/>
                <p:nvPr/>
              </p:nvGrpSpPr>
              <p:grpSpPr>
                <a:xfrm>
                  <a:off x="6107685" y="9182992"/>
                  <a:ext cx="2980185" cy="2492239"/>
                  <a:chOff x="6107685" y="9182992"/>
                  <a:chExt cx="2980185" cy="2492239"/>
                </a:xfrm>
              </p:grpSpPr>
              <p:grpSp>
                <p:nvGrpSpPr>
                  <p:cNvPr id="161" name="그룹 251"/>
                  <p:cNvGrpSpPr/>
                  <p:nvPr/>
                </p:nvGrpSpPr>
                <p:grpSpPr>
                  <a:xfrm>
                    <a:off x="6107685" y="9182992"/>
                    <a:ext cx="2980185" cy="2492239"/>
                    <a:chOff x="2156607" y="4907607"/>
                    <a:chExt cx="2980185" cy="2492239"/>
                  </a:xfrm>
                </p:grpSpPr>
                <p:pic>
                  <p:nvPicPr>
                    <p:cNvPr id="163" name="그림 253"/>
                    <p:cNvPicPr>
                      <a:picLocks noChangeAspect="1"/>
                    </p:cNvPicPr>
                    <p:nvPr/>
                  </p:nvPicPr>
                  <p:blipFill rotWithShape="1"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5" b="15563"/>
                    <a:stretch/>
                  </p:blipFill>
                  <p:spPr>
                    <a:xfrm>
                      <a:off x="2156607" y="4907607"/>
                      <a:ext cx="2980185" cy="2492239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64" name="TextBox 163">
                      <a:extLst>
                        <a:ext uri="{FF2B5EF4-FFF2-40B4-BE49-F238E27FC236}">
                          <a16:creationId xmlns:a16="http://schemas.microsoft.com/office/drawing/2014/main" id="{BBA01E0F-4419-4C18-ACA1-5DB9D162C9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49070" y="5593285"/>
                      <a:ext cx="1276553" cy="26161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Inflammation</a:t>
                      </a:r>
                    </a:p>
                  </p:txBody>
                </p:sp>
              </p:grpSp>
              <p:sp>
                <p:nvSpPr>
                  <p:cNvPr id="162" name="TextBox 161"/>
                  <p:cNvSpPr txBox="1"/>
                  <p:nvPr/>
                </p:nvSpPr>
                <p:spPr>
                  <a:xfrm>
                    <a:off x="8076392" y="9347463"/>
                    <a:ext cx="576064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60" name="TextBox 159"/>
                <p:cNvSpPr txBox="1"/>
                <p:nvPr/>
              </p:nvSpPr>
              <p:spPr>
                <a:xfrm>
                  <a:off x="8276740" y="9236682"/>
                  <a:ext cx="731741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 Black" panose="020B0A04020102020204" pitchFamily="34" charset="0"/>
                    </a:rPr>
                    <a:t>p=0.211</a:t>
                  </a:r>
                  <a:endParaRPr lang="ko-KR" altLang="en-US" sz="1000" b="1" dirty="0">
                    <a:latin typeface="Arial Black" panose="020B0A04020102020204" pitchFamily="34" charset="0"/>
                  </a:endParaRPr>
                </a:p>
              </p:txBody>
            </p:sp>
          </p:grp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B8E093EF-12FE-4816-8B5D-702F8962A487}"/>
                </a:ext>
              </a:extLst>
            </p:cNvPr>
            <p:cNvSpPr txBox="1"/>
            <p:nvPr/>
          </p:nvSpPr>
          <p:spPr>
            <a:xfrm>
              <a:off x="6061093" y="4320383"/>
              <a:ext cx="63064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B8E093EF-12FE-4816-8B5D-702F8962A487}"/>
                </a:ext>
              </a:extLst>
            </p:cNvPr>
            <p:cNvSpPr txBox="1"/>
            <p:nvPr/>
          </p:nvSpPr>
          <p:spPr>
            <a:xfrm>
              <a:off x="6032105" y="4830355"/>
              <a:ext cx="68862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e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B8E093EF-12FE-4816-8B5D-702F8962A487}"/>
                </a:ext>
              </a:extLst>
            </p:cNvPr>
            <p:cNvSpPr txBox="1"/>
            <p:nvPr/>
          </p:nvSpPr>
          <p:spPr>
            <a:xfrm>
              <a:off x="7897654" y="4768229"/>
              <a:ext cx="67141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e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B8E093EF-12FE-4816-8B5D-702F8962A487}"/>
                </a:ext>
              </a:extLst>
            </p:cNvPr>
            <p:cNvSpPr txBox="1"/>
            <p:nvPr/>
          </p:nvSpPr>
          <p:spPr>
            <a:xfrm>
              <a:off x="9378939" y="4411272"/>
              <a:ext cx="62780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6004746" y="7293622"/>
              <a:ext cx="62764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6144747" y="7595769"/>
              <a:ext cx="68607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e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9493701" y="7518285"/>
              <a:ext cx="62914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7629146" y="7513115"/>
              <a:ext cx="68093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e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5716278" y="9565778"/>
              <a:ext cx="1231937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Well differentiated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5091882" y="9924835"/>
              <a:ext cx="178482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Moderately differentiated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4406877" y="10428332"/>
              <a:ext cx="154454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oorly differentiated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7848018" y="10419815"/>
              <a:ext cx="207905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err="1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ancreatobiliary</a:t>
              </a:r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 subtyp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8924244" y="9983514"/>
              <a:ext cx="1215526" cy="50783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one to  </a:t>
              </a:r>
              <a:r>
                <a:rPr lang="en-US" sz="900" b="1" dirty="0" err="1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ancreatobiliary</a:t>
              </a:r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 subtype 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8350763" y="9706035"/>
              <a:ext cx="1388861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Prone to intestinal subtyp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8628649" y="9491216"/>
              <a:ext cx="131448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Intestinal subtyp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5332862" y="13136371"/>
              <a:ext cx="780513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Moderat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4968775" y="11339473"/>
              <a:ext cx="68316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A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6127056" y="12771728"/>
              <a:ext cx="46447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Mild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5808576" y="13280081"/>
              <a:ext cx="6324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ever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9165381" y="13221506"/>
              <a:ext cx="67623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 Black" panose="020B0A0402010202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bsent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9136138" y="13062494"/>
              <a:ext cx="77796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Moderat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BB5D9038-49D6-4BDD-BA6C-6FEE27EF9936}"/>
                </a:ext>
              </a:extLst>
            </p:cNvPr>
            <p:cNvSpPr txBox="1"/>
            <p:nvPr/>
          </p:nvSpPr>
          <p:spPr>
            <a:xfrm>
              <a:off x="8596575" y="12973628"/>
              <a:ext cx="61777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Severe</a:t>
              </a:r>
              <a:endParaRPr lang="en-US" sz="900" b="1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007437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7A1FE1BF-5739-49B6-A03B-AF7537DE2A5D}"/>
              </a:ext>
            </a:extLst>
          </p:cNvPr>
          <p:cNvSpPr txBox="1"/>
          <p:nvPr/>
        </p:nvSpPr>
        <p:spPr>
          <a:xfrm>
            <a:off x="3025000" y="10383049"/>
            <a:ext cx="79928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analysis on the relationship between diseas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surviv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and expression level of  the IHC markers in recurrent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iampullary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pancreatic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s. There was no significant difference according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K20, and (D) VEGF, while there was significant difference according to (B) CDX2, and (C) FGFR1,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068244" y="1809047"/>
            <a:ext cx="9685500" cy="7912604"/>
            <a:chOff x="3349265" y="3384947"/>
            <a:chExt cx="6620245" cy="5408433"/>
          </a:xfrm>
        </p:grpSpPr>
        <p:grpSp>
          <p:nvGrpSpPr>
            <p:cNvPr id="76" name="그룹 75"/>
            <p:cNvGrpSpPr/>
            <p:nvPr/>
          </p:nvGrpSpPr>
          <p:grpSpPr>
            <a:xfrm>
              <a:off x="3349265" y="3384947"/>
              <a:ext cx="6587009" cy="5408433"/>
              <a:chOff x="3052131" y="2224986"/>
              <a:chExt cx="6587009" cy="5408433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10ED5E60-BEBB-4AD2-B113-7B834F4DB424}"/>
                  </a:ext>
                </a:extLst>
              </p:cNvPr>
              <p:cNvSpPr txBox="1"/>
              <p:nvPr/>
            </p:nvSpPr>
            <p:spPr>
              <a:xfrm>
                <a:off x="3052131" y="2237048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A.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0A4146DC-4497-4450-B452-49B8FA9BA704}"/>
                  </a:ext>
                </a:extLst>
              </p:cNvPr>
              <p:cNvSpPr txBox="1"/>
              <p:nvPr/>
            </p:nvSpPr>
            <p:spPr>
              <a:xfrm>
                <a:off x="6397057" y="2224986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B.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15C90AE8-1BF2-4399-A383-F4F9BA99CB63}"/>
                  </a:ext>
                </a:extLst>
              </p:cNvPr>
              <p:cNvSpPr txBox="1"/>
              <p:nvPr/>
            </p:nvSpPr>
            <p:spPr>
              <a:xfrm>
                <a:off x="3071998" y="5037109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C.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8421C2DF-CFC3-4846-AECE-1BE7B1996054}"/>
                  </a:ext>
                </a:extLst>
              </p:cNvPr>
              <p:cNvSpPr txBox="1"/>
              <p:nvPr/>
            </p:nvSpPr>
            <p:spPr>
              <a:xfrm>
                <a:off x="6426746" y="5041887"/>
                <a:ext cx="360040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D.</a:t>
                </a: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8761981" y="2463722"/>
                <a:ext cx="412185" cy="1871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ko-KR" altLang="en-US" dirty="0"/>
              </a:p>
            </p:txBody>
          </p:sp>
          <p:grpSp>
            <p:nvGrpSpPr>
              <p:cNvPr id="97" name="그룹 96"/>
              <p:cNvGrpSpPr/>
              <p:nvPr/>
            </p:nvGrpSpPr>
            <p:grpSpPr>
              <a:xfrm>
                <a:off x="3362840" y="5128344"/>
                <a:ext cx="2978713" cy="2499946"/>
                <a:chOff x="5403667" y="3063798"/>
                <a:chExt cx="2978713" cy="2499946"/>
              </a:xfrm>
            </p:grpSpPr>
            <p:grpSp>
              <p:nvGrpSpPr>
                <p:cNvPr id="137" name="그룹 136"/>
                <p:cNvGrpSpPr/>
                <p:nvPr/>
              </p:nvGrpSpPr>
              <p:grpSpPr>
                <a:xfrm>
                  <a:off x="5403667" y="3063798"/>
                  <a:ext cx="2978713" cy="2499946"/>
                  <a:chOff x="5403667" y="3061256"/>
                  <a:chExt cx="2978713" cy="2499946"/>
                </a:xfrm>
              </p:grpSpPr>
              <p:grpSp>
                <p:nvGrpSpPr>
                  <p:cNvPr id="139" name="그룹 138"/>
                  <p:cNvGrpSpPr/>
                  <p:nvPr/>
                </p:nvGrpSpPr>
                <p:grpSpPr>
                  <a:xfrm>
                    <a:off x="5403667" y="3061256"/>
                    <a:ext cx="2978713" cy="2499946"/>
                    <a:chOff x="5403667" y="3061256"/>
                    <a:chExt cx="2978713" cy="2499946"/>
                  </a:xfrm>
                </p:grpSpPr>
                <p:pic>
                  <p:nvPicPr>
                    <p:cNvPr id="141" name="그림 140"/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644" b="15564"/>
                    <a:stretch/>
                  </p:blipFill>
                  <p:spPr>
                    <a:xfrm>
                      <a:off x="5403667" y="3061256"/>
                      <a:ext cx="2978713" cy="2499946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sp>
                  <p:nvSpPr>
                    <p:cNvPr id="142" name="TextBox 141">
                      <a:extLst>
                        <a:ext uri="{FF2B5EF4-FFF2-40B4-BE49-F238E27FC236}">
                          <a16:creationId xmlns:a16="http://schemas.microsoft.com/office/drawing/2014/main" id="{54950EAE-80AD-4B6A-86A5-1BA96DFAF4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37083" y="3798754"/>
                      <a:ext cx="705350" cy="24622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 Black" panose="020B0A04020102020204" pitchFamily="34" charset="0"/>
                          <a:cs typeface="Times New Roman" panose="02020603050405020304" pitchFamily="18" charset="0"/>
                        </a:rPr>
                        <a:t>FGFR-1</a:t>
                      </a:r>
                    </a:p>
                  </p:txBody>
                </p:sp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7420128" y="3577580"/>
                      <a:ext cx="648072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ko-KR" altLang="en-US" sz="1200" dirty="0"/>
                    </a:p>
                  </p:txBody>
                </p:sp>
              </p:grp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7508714" y="3192451"/>
                    <a:ext cx="429056" cy="24622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000" dirty="0"/>
                  </a:p>
                </p:txBody>
              </p:sp>
            </p:grpSp>
            <p:sp>
              <p:nvSpPr>
                <p:cNvPr id="138" name="TextBox 137"/>
                <p:cNvSpPr txBox="1"/>
                <p:nvPr/>
              </p:nvSpPr>
              <p:spPr>
                <a:xfrm>
                  <a:off x="7417006" y="3122621"/>
                  <a:ext cx="857815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 Black" panose="020B0A04020102020204" pitchFamily="34" charset="0"/>
                    </a:rPr>
                    <a:t>p=0.0181</a:t>
                  </a:r>
                  <a:endParaRPr lang="ko-KR" altLang="en-US" sz="1000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98" name="그룹 97"/>
              <p:cNvGrpSpPr/>
              <p:nvPr/>
            </p:nvGrpSpPr>
            <p:grpSpPr>
              <a:xfrm>
                <a:off x="6654781" y="5120428"/>
                <a:ext cx="2980185" cy="2512991"/>
                <a:chOff x="8707234" y="3036208"/>
                <a:chExt cx="2980185" cy="2492239"/>
              </a:xfrm>
            </p:grpSpPr>
            <p:grpSp>
              <p:nvGrpSpPr>
                <p:cNvPr id="132" name="그룹 131"/>
                <p:cNvGrpSpPr/>
                <p:nvPr/>
              </p:nvGrpSpPr>
              <p:grpSpPr>
                <a:xfrm>
                  <a:off x="8707234" y="3036208"/>
                  <a:ext cx="2980185" cy="2492239"/>
                  <a:chOff x="8707234" y="3036208"/>
                  <a:chExt cx="2980185" cy="2492239"/>
                </a:xfrm>
              </p:grpSpPr>
              <p:pic>
                <p:nvPicPr>
                  <p:cNvPr id="134" name="그림 133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3644" b="15564"/>
                  <a:stretch/>
                </p:blipFill>
                <p:spPr>
                  <a:xfrm>
                    <a:off x="8707234" y="3036208"/>
                    <a:ext cx="2980185" cy="2492239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135" name="TextBox 134">
                    <a:extLst>
                      <a:ext uri="{FF2B5EF4-FFF2-40B4-BE49-F238E27FC236}">
                        <a16:creationId xmlns:a16="http://schemas.microsoft.com/office/drawing/2014/main" id="{E1332884-E552-4B26-8CF6-4225C32B1F04}"/>
                      </a:ext>
                    </a:extLst>
                  </p:cNvPr>
                  <p:cNvSpPr txBox="1"/>
                  <p:nvPr/>
                </p:nvSpPr>
                <p:spPr>
                  <a:xfrm>
                    <a:off x="10101994" y="3757388"/>
                    <a:ext cx="615797" cy="24622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VEGF</a:t>
                    </a:r>
                  </a:p>
                </p:txBody>
              </p: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10675218" y="3161673"/>
                    <a:ext cx="648072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33" name="TextBox 132"/>
                <p:cNvSpPr txBox="1"/>
                <p:nvPr/>
              </p:nvSpPr>
              <p:spPr>
                <a:xfrm>
                  <a:off x="10814434" y="3102395"/>
                  <a:ext cx="769399" cy="244188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 Black" panose="020B0A04020102020204" pitchFamily="34" charset="0"/>
                    </a:rPr>
                    <a:t>p=0.208</a:t>
                  </a:r>
                  <a:endParaRPr lang="ko-KR" altLang="en-US" sz="1000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99" name="그룹 98"/>
              <p:cNvGrpSpPr/>
              <p:nvPr/>
            </p:nvGrpSpPr>
            <p:grpSpPr>
              <a:xfrm>
                <a:off x="3358246" y="2310948"/>
                <a:ext cx="2980185" cy="2501141"/>
                <a:chOff x="3358246" y="2310948"/>
                <a:chExt cx="2980185" cy="2501141"/>
              </a:xfrm>
            </p:grpSpPr>
            <p:grpSp>
              <p:nvGrpSpPr>
                <p:cNvPr id="118" name="그룹 117"/>
                <p:cNvGrpSpPr/>
                <p:nvPr/>
              </p:nvGrpSpPr>
              <p:grpSpPr>
                <a:xfrm>
                  <a:off x="3358246" y="2310948"/>
                  <a:ext cx="2980185" cy="2501141"/>
                  <a:chOff x="5402195" y="254858"/>
                  <a:chExt cx="2980185" cy="2501141"/>
                </a:xfrm>
              </p:grpSpPr>
              <p:pic>
                <p:nvPicPr>
                  <p:cNvPr id="129" name="그림 128"/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3973" b="15236"/>
                  <a:stretch/>
                </p:blipFill>
                <p:spPr>
                  <a:xfrm>
                    <a:off x="5402195" y="254858"/>
                    <a:ext cx="2980185" cy="2501141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130" name="TextBox 129">
                    <a:extLst>
                      <a:ext uri="{FF2B5EF4-FFF2-40B4-BE49-F238E27FC236}">
                        <a16:creationId xmlns:a16="http://schemas.microsoft.com/office/drawing/2014/main" id="{9EC48284-915A-450B-81DE-BAB543BBDAC3}"/>
                      </a:ext>
                    </a:extLst>
                  </p:cNvPr>
                  <p:cNvSpPr txBox="1"/>
                  <p:nvPr/>
                </p:nvSpPr>
                <p:spPr>
                  <a:xfrm>
                    <a:off x="6948133" y="942817"/>
                    <a:ext cx="609990" cy="24622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CK20</a:t>
                    </a:r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7420128" y="388529"/>
                    <a:ext cx="648072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28" name="TextBox 127"/>
                <p:cNvSpPr txBox="1"/>
                <p:nvPr/>
              </p:nvSpPr>
              <p:spPr>
                <a:xfrm>
                  <a:off x="5474432" y="2357705"/>
                  <a:ext cx="760580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 Black" panose="020B0A04020102020204" pitchFamily="34" charset="0"/>
                    </a:rPr>
                    <a:t>p=0.179</a:t>
                  </a:r>
                  <a:endParaRPr lang="ko-KR" altLang="en-US" sz="1000" dirty="0">
                    <a:latin typeface="Arial Black" panose="020B0A04020102020204" pitchFamily="34" charset="0"/>
                  </a:endParaRPr>
                </a:p>
              </p:txBody>
            </p:sp>
          </p:grpSp>
          <p:grpSp>
            <p:nvGrpSpPr>
              <p:cNvPr id="107" name="그룹 106"/>
              <p:cNvGrpSpPr/>
              <p:nvPr/>
            </p:nvGrpSpPr>
            <p:grpSpPr>
              <a:xfrm>
                <a:off x="6658955" y="2303999"/>
                <a:ext cx="2980185" cy="2500549"/>
                <a:chOff x="10227646" y="2240181"/>
                <a:chExt cx="2980185" cy="2500549"/>
              </a:xfrm>
            </p:grpSpPr>
            <p:grpSp>
              <p:nvGrpSpPr>
                <p:cNvPr id="108" name="그룹 107"/>
                <p:cNvGrpSpPr/>
                <p:nvPr/>
              </p:nvGrpSpPr>
              <p:grpSpPr>
                <a:xfrm>
                  <a:off x="10227646" y="2240181"/>
                  <a:ext cx="2980185" cy="2500549"/>
                  <a:chOff x="8707234" y="223636"/>
                  <a:chExt cx="2980185" cy="2500549"/>
                </a:xfrm>
              </p:grpSpPr>
              <p:pic>
                <p:nvPicPr>
                  <p:cNvPr id="110" name="그림 109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3644" b="15564"/>
                  <a:stretch/>
                </p:blipFill>
                <p:spPr>
                  <a:xfrm>
                    <a:off x="8707234" y="223636"/>
                    <a:ext cx="2980185" cy="2500549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C8E28FBD-67B7-416E-95CF-A61286E617C2}"/>
                      </a:ext>
                    </a:extLst>
                  </p:cNvPr>
                  <p:cNvSpPr txBox="1"/>
                  <p:nvPr/>
                </p:nvSpPr>
                <p:spPr>
                  <a:xfrm>
                    <a:off x="10082384" y="930603"/>
                    <a:ext cx="621908" cy="24622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 Black" panose="020B0A04020102020204" pitchFamily="34" charset="0"/>
                        <a:cs typeface="Times New Roman" panose="02020603050405020304" pitchFamily="18" charset="0"/>
                      </a:rPr>
                      <a:t>CDX2</a:t>
                    </a:r>
                  </a:p>
                </p:txBody>
              </p:sp>
              <p:sp>
                <p:nvSpPr>
                  <p:cNvPr id="114" name="TextBox 113"/>
                  <p:cNvSpPr txBox="1"/>
                  <p:nvPr/>
                </p:nvSpPr>
                <p:spPr>
                  <a:xfrm>
                    <a:off x="10665935" y="342691"/>
                    <a:ext cx="648072" cy="2769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ko-KR" altLang="en-US" sz="1200" dirty="0"/>
                  </a:p>
                </p:txBody>
              </p:sp>
            </p:grpSp>
            <p:sp>
              <p:nvSpPr>
                <p:cNvPr id="109" name="TextBox 108"/>
                <p:cNvSpPr txBox="1"/>
                <p:nvPr/>
              </p:nvSpPr>
              <p:spPr>
                <a:xfrm>
                  <a:off x="12250914" y="2301462"/>
                  <a:ext cx="845403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 Black" panose="020B0A04020102020204" pitchFamily="34" charset="0"/>
                    </a:rPr>
                    <a:t>p=0.0245</a:t>
                  </a:r>
                  <a:endParaRPr lang="ko-KR" altLang="en-US" sz="1000" dirty="0">
                    <a:latin typeface="Arial Black" panose="020B0A04020102020204" pitchFamily="34" charset="0"/>
                  </a:endParaRPr>
                </a:p>
              </p:txBody>
            </p:sp>
          </p:grpSp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3906466" y="7818592"/>
              <a:ext cx="3965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1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6263860" y="8260512"/>
              <a:ext cx="346481" cy="23598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2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5975989" y="8124965"/>
              <a:ext cx="34539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3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9505694" y="7739447"/>
              <a:ext cx="36321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3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7984032" y="8353499"/>
              <a:ext cx="3965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1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5092845" y="5499163"/>
              <a:ext cx="36756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1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5573283" y="4957737"/>
              <a:ext cx="35705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2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6198597" y="4645295"/>
              <a:ext cx="37085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3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9620898" y="5568444"/>
              <a:ext cx="34861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1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8695904" y="4848586"/>
              <a:ext cx="36321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2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8877509" y="4459672"/>
              <a:ext cx="38842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3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9471300" y="5442550"/>
              <a:ext cx="29919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 Black" panose="020B0A04020102020204" pitchFamily="34" charset="0"/>
                  <a:cs typeface="Times New Roman" panose="02020603050405020304" pitchFamily="18" charset="0"/>
                </a:rPr>
                <a:t>0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6194843" y="5517038"/>
              <a:ext cx="337303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 Black" panose="020B0A04020102020204" pitchFamily="34" charset="0"/>
                  <a:cs typeface="Times New Roman" panose="02020603050405020304" pitchFamily="18" charset="0"/>
                </a:rPr>
                <a:t>0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54950EAE-80AD-4B6A-86A5-1BA96DFAF486}"/>
                </a:ext>
              </a:extLst>
            </p:cNvPr>
            <p:cNvSpPr txBox="1"/>
            <p:nvPr/>
          </p:nvSpPr>
          <p:spPr>
            <a:xfrm>
              <a:off x="9451082" y="8009549"/>
              <a:ext cx="38842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 Black" panose="020B0A04020102020204" pitchFamily="34" charset="0"/>
                  <a:cs typeface="Times New Roman" panose="02020603050405020304" pitchFamily="18" charset="0"/>
                </a:rPr>
                <a:t>2</a:t>
              </a:r>
              <a:r>
                <a:rPr lang="en-US" sz="900" dirty="0" smtClean="0">
                  <a:latin typeface="Arial Black" panose="020B0A04020102020204" pitchFamily="34" charset="0"/>
                  <a:cs typeface="Times New Roman" panose="02020603050405020304" pitchFamily="18" charset="0"/>
                </a:rPr>
                <a:t>+</a:t>
              </a:r>
              <a:endParaRPr lang="en-US" sz="900" dirty="0">
                <a:latin typeface="Arial Black" panose="020B0A0402010202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51050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6426746" y="11111507"/>
            <a:ext cx="504056" cy="28803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1FE1BF-5739-49B6-A03B-AF7537DE2A5D}"/>
              </a:ext>
            </a:extLst>
          </p:cNvPr>
          <p:cNvSpPr txBox="1"/>
          <p:nvPr/>
        </p:nvSpPr>
        <p:spPr>
          <a:xfrm>
            <a:off x="3109911" y="12274334"/>
            <a:ext cx="76373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Cox regression analysis of FGFR 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iampullar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pancreati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.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vival probability of FGFR1+, 2+, 3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n-US" sz="1200" dirty="0" smtClean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en-US" sz="12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g-Log </a:t>
            </a:r>
            <a:r>
              <a:rPr lang="en-US" sz="1200" dirty="0" smtClean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probability of FGFRs 1+, 2+, 3+ group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Group 53"/>
          <p:cNvGrpSpPr/>
          <p:nvPr/>
        </p:nvGrpSpPr>
        <p:grpSpPr>
          <a:xfrm>
            <a:off x="3710226" y="2237534"/>
            <a:ext cx="6532944" cy="9201532"/>
            <a:chOff x="3116700" y="2448843"/>
            <a:chExt cx="6532944" cy="9201532"/>
          </a:xfrm>
        </p:grpSpPr>
        <p:sp>
          <p:nvSpPr>
            <p:cNvPr id="55" name="TextBox 54"/>
            <p:cNvSpPr txBox="1"/>
            <p:nvPr/>
          </p:nvSpPr>
          <p:spPr>
            <a:xfrm>
              <a:off x="3116700" y="244884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 Black" panose="020B0A04020102020204" pitchFamily="34" charset="0"/>
                  <a:cs typeface="Arial" panose="020B0604020202020204" pitchFamily="34" charset="0"/>
                </a:rPr>
                <a:t>A.</a:t>
              </a:r>
              <a:endParaRPr lang="en-GB" sz="1000" dirty="0"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116700" y="7023775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 Black" panose="020B0A04020102020204" pitchFamily="34" charset="0"/>
                  <a:cs typeface="Arial" panose="020B0604020202020204" pitchFamily="34" charset="0"/>
                </a:rPr>
                <a:t>B</a:t>
              </a:r>
              <a:r>
                <a:rPr lang="en-GB" sz="1000" dirty="0" smtClean="0">
                  <a:latin typeface="Arial Black" panose="020B0A040201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7" name="Group 56"/>
            <p:cNvGrpSpPr/>
            <p:nvPr/>
          </p:nvGrpSpPr>
          <p:grpSpPr>
            <a:xfrm>
              <a:off x="3116918" y="7146885"/>
              <a:ext cx="6532726" cy="4503490"/>
              <a:chOff x="3598112" y="7147399"/>
              <a:chExt cx="6532726" cy="4503490"/>
            </a:xfrm>
          </p:grpSpPr>
          <p:sp>
            <p:nvSpPr>
              <p:cNvPr id="64" name="TextBox 63"/>
              <p:cNvSpPr txBox="1"/>
              <p:nvPr/>
            </p:nvSpPr>
            <p:spPr>
              <a:xfrm rot="16200000">
                <a:off x="1769690" y="9019900"/>
                <a:ext cx="39030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 smtClean="0">
                    <a:latin typeface="Arial Black" panose="020B0A04020102020204" pitchFamily="34" charset="0"/>
                    <a:cs typeface="Arial" panose="020B0604020202020204" pitchFamily="34" charset="0"/>
                  </a:rPr>
                  <a:t>Log-Log Survival Probability</a:t>
                </a:r>
                <a:endParaRPr lang="en-GB" sz="1000" b="1" dirty="0">
                  <a:latin typeface="Arial Black" panose="020B0A040201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5" name="Group 64"/>
              <p:cNvGrpSpPr/>
              <p:nvPr/>
            </p:nvGrpSpPr>
            <p:grpSpPr>
              <a:xfrm>
                <a:off x="3938150" y="7147399"/>
                <a:ext cx="6192688" cy="4503490"/>
                <a:chOff x="3938150" y="7147399"/>
                <a:chExt cx="6192688" cy="4503490"/>
              </a:xfrm>
            </p:grpSpPr>
            <p:grpSp>
              <p:nvGrpSpPr>
                <p:cNvPr id="66" name="Group 65"/>
                <p:cNvGrpSpPr/>
                <p:nvPr/>
              </p:nvGrpSpPr>
              <p:grpSpPr>
                <a:xfrm>
                  <a:off x="3938150" y="7147399"/>
                  <a:ext cx="6192688" cy="4503490"/>
                  <a:chOff x="3896340" y="5988202"/>
                  <a:chExt cx="6192688" cy="4503490"/>
                </a:xfrm>
              </p:grpSpPr>
              <p:pic>
                <p:nvPicPr>
                  <p:cNvPr id="68" name="Picture 67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774" t="5627" r="17827"/>
                  <a:stretch/>
                </p:blipFill>
                <p:spPr>
                  <a:xfrm>
                    <a:off x="3896340" y="5988202"/>
                    <a:ext cx="6192688" cy="4503490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6354738" y="10153700"/>
                    <a:ext cx="762178" cy="29846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7A1FE1BF-5739-49B6-A03B-AF7537DE2A5D}"/>
                    </a:ext>
                  </a:extLst>
                </p:cNvPr>
                <p:cNvSpPr txBox="1"/>
                <p:nvPr/>
              </p:nvSpPr>
              <p:spPr>
                <a:xfrm>
                  <a:off x="4041332" y="11367589"/>
                  <a:ext cx="5472609" cy="246221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smtClean="0"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Overall Survival Time(days)</a:t>
                  </a:r>
                  <a:r>
                    <a:rPr lang="en-US" sz="1000" smtClean="0">
                      <a:latin typeface="Arial Black" panose="020B0A04020102020204" pitchFamily="34" charset="0"/>
                      <a:cs typeface="Times New Roman" panose="02020603050405020304" pitchFamily="18" charset="0"/>
                    </a:rPr>
                    <a:t> </a:t>
                  </a:r>
                  <a:endPara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58" name="Group 57"/>
            <p:cNvGrpSpPr/>
            <p:nvPr/>
          </p:nvGrpSpPr>
          <p:grpSpPr>
            <a:xfrm>
              <a:off x="3116700" y="2613888"/>
              <a:ext cx="6441151" cy="4491063"/>
              <a:chOff x="3511664" y="2448843"/>
              <a:chExt cx="6441151" cy="4491063"/>
            </a:xfrm>
          </p:grpSpPr>
          <p:sp>
            <p:nvSpPr>
              <p:cNvPr id="59" name="TextBox 58"/>
              <p:cNvSpPr txBox="1"/>
              <p:nvPr/>
            </p:nvSpPr>
            <p:spPr>
              <a:xfrm rot="16200000">
                <a:off x="1696704" y="4263803"/>
                <a:ext cx="3881362" cy="2514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 smtClean="0">
                    <a:latin typeface="Arial Black" panose="020B0A04020102020204" pitchFamily="34" charset="0"/>
                    <a:cs typeface="Arial" panose="020B0604020202020204" pitchFamily="34" charset="0"/>
                  </a:rPr>
                  <a:t> Survival </a:t>
                </a:r>
                <a:r>
                  <a:rPr lang="en-GB" sz="1000" b="1" dirty="0">
                    <a:latin typeface="Arial Black" panose="020B0A040201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GB" sz="1000" b="1" dirty="0" smtClean="0">
                    <a:latin typeface="Arial Black" panose="020B0A04020102020204" pitchFamily="34" charset="0"/>
                    <a:cs typeface="Arial" panose="020B0604020202020204" pitchFamily="34" charset="0"/>
                  </a:rPr>
                  <a:t>robability</a:t>
                </a:r>
                <a:endParaRPr lang="en-GB" sz="1000" b="1" dirty="0">
                  <a:latin typeface="Arial Black" panose="020B0A040201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0" name="Group 59"/>
              <p:cNvGrpSpPr/>
              <p:nvPr/>
            </p:nvGrpSpPr>
            <p:grpSpPr>
              <a:xfrm>
                <a:off x="3760127" y="2455913"/>
                <a:ext cx="6192688" cy="4483993"/>
                <a:chOff x="3760127" y="2455913"/>
                <a:chExt cx="6192688" cy="4483993"/>
              </a:xfrm>
            </p:grpSpPr>
            <p:pic>
              <p:nvPicPr>
                <p:cNvPr id="62" name="Picture 61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442" t="6036" r="19160"/>
                <a:stretch/>
              </p:blipFill>
              <p:spPr>
                <a:xfrm>
                  <a:off x="3760127" y="2455913"/>
                  <a:ext cx="6192688" cy="4483993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sp>
              <p:nvSpPr>
                <p:cNvPr id="63" name="TextBox 62"/>
                <p:cNvSpPr txBox="1"/>
                <p:nvPr/>
              </p:nvSpPr>
              <p:spPr>
                <a:xfrm>
                  <a:off x="6540931" y="6625307"/>
                  <a:ext cx="533887" cy="21602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GB" dirty="0"/>
                </a:p>
              </p:txBody>
            </p:sp>
          </p:grp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7A1FE1BF-5739-49B6-A03B-AF7537DE2A5D}"/>
                  </a:ext>
                </a:extLst>
              </p:cNvPr>
              <p:cNvSpPr txBox="1"/>
              <p:nvPr/>
            </p:nvSpPr>
            <p:spPr>
              <a:xfrm>
                <a:off x="4010017" y="6616202"/>
                <a:ext cx="5472609" cy="24622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Overall </a:t>
                </a:r>
                <a:r>
                  <a:rPr lang="en-US" sz="1000" dirty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S</a:t>
                </a:r>
                <a:r>
                  <a:rPr lang="en-US" sz="1000" dirty="0" smtClean="0">
                    <a:latin typeface="Arial Black" panose="020B0A04020102020204" pitchFamily="34" charset="0"/>
                    <a:cs typeface="Times New Roman" panose="02020603050405020304" pitchFamily="18" charset="0"/>
                  </a:rPr>
                  <a:t>urvival Time( days) </a:t>
                </a:r>
                <a:endParaRPr lang="en-US" sz="1000" dirty="0">
                  <a:latin typeface="Arial Black" panose="020B0A0402010202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70973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75</TotalTime>
  <Words>570</Words>
  <Application>Microsoft Office PowerPoint</Application>
  <PresentationFormat>Custom</PresentationFormat>
  <Paragraphs>13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굴림</vt:lpstr>
      <vt:lpstr>맑은 고딕</vt:lpstr>
      <vt:lpstr>Arial</vt:lpstr>
      <vt:lpstr>Arial Black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Abella, Jerard Dave</cp:lastModifiedBy>
  <cp:revision>6075</cp:revision>
  <cp:lastPrinted>2018-05-10T02:16:41Z</cp:lastPrinted>
  <dcterms:created xsi:type="dcterms:W3CDTF">2012-12-27T10:55:41Z</dcterms:created>
  <dcterms:modified xsi:type="dcterms:W3CDTF">2020-03-07T06:33:25Z</dcterms:modified>
</cp:coreProperties>
</file>